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90" r:id="rId2"/>
    <p:sldId id="291" r:id="rId3"/>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6196" autoAdjust="0"/>
    <p:restoredTop sz="94660"/>
  </p:normalViewPr>
  <p:slideViewPr>
    <p:cSldViewPr snapToGrid="0">
      <p:cViewPr varScale="1">
        <p:scale>
          <a:sx n="76" d="100"/>
          <a:sy n="76" d="100"/>
        </p:scale>
        <p:origin x="3144" y="9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Schuster Gadi" userId="8014ead3-d102-41a2-8e53-d5bceadeebe2" providerId="ADAL" clId="{E7470423-E9D2-42EB-94C4-F83D031DF650}"/>
    <pc:docChg chg="custSel modSld">
      <pc:chgData name="Schuster Gadi" userId="8014ead3-d102-41a2-8e53-d5bceadeebe2" providerId="ADAL" clId="{E7470423-E9D2-42EB-94C4-F83D031DF650}" dt="2024-05-29T08:41:43.930" v="4" actId="1076"/>
      <pc:docMkLst>
        <pc:docMk/>
      </pc:docMkLst>
      <pc:sldChg chg="modSp mod">
        <pc:chgData name="Schuster Gadi" userId="8014ead3-d102-41a2-8e53-d5bceadeebe2" providerId="ADAL" clId="{E7470423-E9D2-42EB-94C4-F83D031DF650}" dt="2024-05-29T08:41:43.930" v="4" actId="1076"/>
        <pc:sldMkLst>
          <pc:docMk/>
          <pc:sldMk cId="2034325348" sldId="1341"/>
        </pc:sldMkLst>
        <pc:spChg chg="mod">
          <ac:chgData name="Schuster Gadi" userId="8014ead3-d102-41a2-8e53-d5bceadeebe2" providerId="ADAL" clId="{E7470423-E9D2-42EB-94C4-F83D031DF650}" dt="2024-05-29T08:41:43.930" v="4" actId="1076"/>
          <ac:spMkLst>
            <pc:docMk/>
            <pc:sldMk cId="2034325348" sldId="1341"/>
            <ac:spMk id="18" creationId="{351D47F2-9952-490B-8F22-8176E75E4E18}"/>
          </ac:spMkLst>
        </pc:spChg>
        <pc:spChg chg="mod">
          <ac:chgData name="Schuster Gadi" userId="8014ead3-d102-41a2-8e53-d5bceadeebe2" providerId="ADAL" clId="{E7470423-E9D2-42EB-94C4-F83D031DF650}" dt="2024-05-28T06:49:29.122" v="1" actId="313"/>
          <ac:spMkLst>
            <pc:docMk/>
            <pc:sldMk cId="2034325348" sldId="1341"/>
            <ac:spMk id="55" creationId="{18D0CA16-79D7-50D2-ACA1-12655DCE9869}"/>
          </ac:spMkLst>
        </pc:spChg>
        <pc:spChg chg="mod">
          <ac:chgData name="Schuster Gadi" userId="8014ead3-d102-41a2-8e53-d5bceadeebe2" providerId="ADAL" clId="{E7470423-E9D2-42EB-94C4-F83D031DF650}" dt="2024-05-28T06:49:33.174" v="3" actId="313"/>
          <ac:spMkLst>
            <pc:docMk/>
            <pc:sldMk cId="2034325348" sldId="1341"/>
            <ac:spMk id="61" creationId="{96332946-C41D-02AC-6D37-BE3997BC9C4A}"/>
          </ac:spMkLst>
        </pc:spChg>
      </pc:sldChg>
    </pc:docChg>
  </pc:docChgLst>
  <pc:docChgLst>
    <pc:chgData name="Guy Levin" userId="796a6ee1-938f-4754-82f4-44af232fdd3d" providerId="ADAL" clId="{71A9A29E-8629-4A1B-A2EC-F9D9E41292AC}"/>
    <pc:docChg chg="undo custSel modSld">
      <pc:chgData name="Guy Levin" userId="796a6ee1-938f-4754-82f4-44af232fdd3d" providerId="ADAL" clId="{71A9A29E-8629-4A1B-A2EC-F9D9E41292AC}" dt="2024-08-27T19:13:45.463" v="16" actId="20577"/>
      <pc:docMkLst>
        <pc:docMk/>
      </pc:docMkLst>
      <pc:sldChg chg="addSp delSp modSp">
        <pc:chgData name="Guy Levin" userId="796a6ee1-938f-4754-82f4-44af232fdd3d" providerId="ADAL" clId="{71A9A29E-8629-4A1B-A2EC-F9D9E41292AC}" dt="2024-08-26T09:09:15.358" v="14" actId="1076"/>
        <pc:sldMkLst>
          <pc:docMk/>
          <pc:sldMk cId="4102523903" sldId="290"/>
        </pc:sldMkLst>
        <pc:spChg chg="del">
          <ac:chgData name="Guy Levin" userId="796a6ee1-938f-4754-82f4-44af232fdd3d" providerId="ADAL" clId="{71A9A29E-8629-4A1B-A2EC-F9D9E41292AC}" dt="2024-08-26T09:08:59.611" v="12" actId="478"/>
          <ac:spMkLst>
            <pc:docMk/>
            <pc:sldMk cId="4102523903" sldId="290"/>
            <ac:spMk id="21" creationId="{058936D1-6581-426F-8746-9048BC216317}"/>
          </ac:spMkLst>
        </pc:spChg>
        <pc:spChg chg="add mod">
          <ac:chgData name="Guy Levin" userId="796a6ee1-938f-4754-82f4-44af232fdd3d" providerId="ADAL" clId="{71A9A29E-8629-4A1B-A2EC-F9D9E41292AC}" dt="2024-08-26T09:09:15.358" v="14" actId="1076"/>
          <ac:spMkLst>
            <pc:docMk/>
            <pc:sldMk cId="4102523903" sldId="290"/>
            <ac:spMk id="28" creationId="{058936D1-6581-426F-8746-9048BC216317}"/>
          </ac:spMkLst>
        </pc:spChg>
      </pc:sldChg>
      <pc:sldChg chg="addSp delSp modSp">
        <pc:chgData name="Guy Levin" userId="796a6ee1-938f-4754-82f4-44af232fdd3d" providerId="ADAL" clId="{71A9A29E-8629-4A1B-A2EC-F9D9E41292AC}" dt="2024-08-26T09:08:43.047" v="8" actId="1076"/>
        <pc:sldMkLst>
          <pc:docMk/>
          <pc:sldMk cId="1432036717" sldId="299"/>
        </pc:sldMkLst>
        <pc:spChg chg="del">
          <ac:chgData name="Guy Levin" userId="796a6ee1-938f-4754-82f4-44af232fdd3d" providerId="ADAL" clId="{71A9A29E-8629-4A1B-A2EC-F9D9E41292AC}" dt="2024-08-26T09:08:27.524" v="4" actId="478"/>
          <ac:spMkLst>
            <pc:docMk/>
            <pc:sldMk cId="1432036717" sldId="299"/>
            <ac:spMk id="3" creationId="{FAEEBF45-B1CE-41D6-8ED1-AE1699FC69DD}"/>
          </ac:spMkLst>
        </pc:spChg>
        <pc:spChg chg="add mod">
          <ac:chgData name="Guy Levin" userId="796a6ee1-938f-4754-82f4-44af232fdd3d" providerId="ADAL" clId="{71A9A29E-8629-4A1B-A2EC-F9D9E41292AC}" dt="2024-08-26T09:08:43.047" v="8" actId="1076"/>
          <ac:spMkLst>
            <pc:docMk/>
            <pc:sldMk cId="1432036717" sldId="299"/>
            <ac:spMk id="26" creationId="{C11AA62B-374B-4F49-ADFB-BCD75BCA9C29}"/>
          </ac:spMkLst>
        </pc:spChg>
        <pc:picChg chg="mod">
          <ac:chgData name="Guy Levin" userId="796a6ee1-938f-4754-82f4-44af232fdd3d" providerId="ADAL" clId="{71A9A29E-8629-4A1B-A2EC-F9D9E41292AC}" dt="2024-08-26T09:08:39.428" v="7" actId="1076"/>
          <ac:picMkLst>
            <pc:docMk/>
            <pc:sldMk cId="1432036717" sldId="299"/>
            <ac:picMk id="4" creationId="{FFC30E95-BD35-4623-996C-6B14A747A8C0}"/>
          </ac:picMkLst>
        </pc:picChg>
      </pc:sldChg>
      <pc:sldChg chg="addSp delSp modSp">
        <pc:chgData name="Guy Levin" userId="796a6ee1-938f-4754-82f4-44af232fdd3d" providerId="ADAL" clId="{71A9A29E-8629-4A1B-A2EC-F9D9E41292AC}" dt="2024-08-26T09:08:56.534" v="11" actId="1076"/>
        <pc:sldMkLst>
          <pc:docMk/>
          <pc:sldMk cId="2828842376" sldId="305"/>
        </pc:sldMkLst>
        <pc:spChg chg="del">
          <ac:chgData name="Guy Levin" userId="796a6ee1-938f-4754-82f4-44af232fdd3d" providerId="ADAL" clId="{71A9A29E-8629-4A1B-A2EC-F9D9E41292AC}" dt="2024-08-26T09:08:49.131" v="9" actId="478"/>
          <ac:spMkLst>
            <pc:docMk/>
            <pc:sldMk cId="2828842376" sldId="305"/>
            <ac:spMk id="42" creationId="{5D37DAEB-9531-4C3F-AB3B-0D625453EAAA}"/>
          </ac:spMkLst>
        </pc:spChg>
        <pc:spChg chg="add mod">
          <ac:chgData name="Guy Levin" userId="796a6ee1-938f-4754-82f4-44af232fdd3d" providerId="ADAL" clId="{71A9A29E-8629-4A1B-A2EC-F9D9E41292AC}" dt="2024-08-26T09:08:56.534" v="11" actId="1076"/>
          <ac:spMkLst>
            <pc:docMk/>
            <pc:sldMk cId="2828842376" sldId="305"/>
            <ac:spMk id="46" creationId="{5D37DAEB-9531-4C3F-AB3B-0D625453EAAA}"/>
          </ac:spMkLst>
        </pc:spChg>
      </pc:sldChg>
      <pc:sldChg chg="addSp delSp modSp">
        <pc:chgData name="Guy Levin" userId="796a6ee1-938f-4754-82f4-44af232fdd3d" providerId="ADAL" clId="{71A9A29E-8629-4A1B-A2EC-F9D9E41292AC}" dt="2024-08-27T19:13:45.463" v="16" actId="20577"/>
        <pc:sldMkLst>
          <pc:docMk/>
          <pc:sldMk cId="2034325348" sldId="1341"/>
        </pc:sldMkLst>
        <pc:spChg chg="del">
          <ac:chgData name="Guy Levin" userId="796a6ee1-938f-4754-82f4-44af232fdd3d" providerId="ADAL" clId="{71A9A29E-8629-4A1B-A2EC-F9D9E41292AC}" dt="2024-08-26T09:08:20.284" v="2" actId="478"/>
          <ac:spMkLst>
            <pc:docMk/>
            <pc:sldMk cId="2034325348" sldId="1341"/>
            <ac:spMk id="18" creationId="{351D47F2-9952-490B-8F22-8176E75E4E18}"/>
          </ac:spMkLst>
        </pc:spChg>
        <pc:spChg chg="add mod">
          <ac:chgData name="Guy Levin" userId="796a6ee1-938f-4754-82f4-44af232fdd3d" providerId="ADAL" clId="{71A9A29E-8629-4A1B-A2EC-F9D9E41292AC}" dt="2024-08-26T09:08:23.286" v="3" actId="1076"/>
          <ac:spMkLst>
            <pc:docMk/>
            <pc:sldMk cId="2034325348" sldId="1341"/>
            <ac:spMk id="31" creationId="{351D47F2-9952-490B-8F22-8176E75E4E18}"/>
          </ac:spMkLst>
        </pc:spChg>
        <pc:spChg chg="mod">
          <ac:chgData name="Guy Levin" userId="796a6ee1-938f-4754-82f4-44af232fdd3d" providerId="ADAL" clId="{71A9A29E-8629-4A1B-A2EC-F9D9E41292AC}" dt="2024-08-27T19:13:45.463" v="16" actId="20577"/>
          <ac:spMkLst>
            <pc:docMk/>
            <pc:sldMk cId="2034325348" sldId="1341"/>
            <ac:spMk id="32" creationId="{4E08334C-5551-4F10-B8D2-414AF554C9CF}"/>
          </ac:spMkLst>
        </pc:spChg>
        <pc:spChg chg="mod">
          <ac:chgData name="Guy Levin" userId="796a6ee1-938f-4754-82f4-44af232fdd3d" providerId="ADAL" clId="{71A9A29E-8629-4A1B-A2EC-F9D9E41292AC}" dt="2024-08-27T19:13:42.712" v="15" actId="20577"/>
          <ac:spMkLst>
            <pc:docMk/>
            <pc:sldMk cId="2034325348" sldId="1341"/>
            <ac:spMk id="39" creationId="{442F91BD-7E58-4516-A0E5-B1741BB1CD70}"/>
          </ac:spMkLst>
        </pc:spChg>
      </pc:sldChg>
    </pc:docChg>
  </pc:docChgLst>
  <pc:docChgLst>
    <pc:chgData name="Guy Levin" userId="796a6ee1-938f-4754-82f4-44af232fdd3d" providerId="ADAL" clId="{65675048-CCC5-4663-A5ED-1EE0BAA0D74C}"/>
    <pc:docChg chg="undo custSel modSld">
      <pc:chgData name="Guy Levin" userId="796a6ee1-938f-4754-82f4-44af232fdd3d" providerId="ADAL" clId="{65675048-CCC5-4663-A5ED-1EE0BAA0D74C}" dt="2024-06-10T12:25:06.540" v="24" actId="478"/>
      <pc:docMkLst>
        <pc:docMk/>
      </pc:docMkLst>
      <pc:sldChg chg="delSp modSp">
        <pc:chgData name="Guy Levin" userId="796a6ee1-938f-4754-82f4-44af232fdd3d" providerId="ADAL" clId="{65675048-CCC5-4663-A5ED-1EE0BAA0D74C}" dt="2024-06-10T12:25:06.540" v="24" actId="478"/>
        <pc:sldMkLst>
          <pc:docMk/>
          <pc:sldMk cId="1432036717" sldId="299"/>
        </pc:sldMkLst>
        <pc:spChg chg="mod">
          <ac:chgData name="Guy Levin" userId="796a6ee1-938f-4754-82f4-44af232fdd3d" providerId="ADAL" clId="{65675048-CCC5-4663-A5ED-1EE0BAA0D74C}" dt="2024-06-10T12:24:12.117" v="23" actId="20577"/>
          <ac:spMkLst>
            <pc:docMk/>
            <pc:sldMk cId="1432036717" sldId="299"/>
            <ac:spMk id="3" creationId="{FAEEBF45-B1CE-41D6-8ED1-AE1699FC69DD}"/>
          </ac:spMkLst>
        </pc:spChg>
        <pc:spChg chg="del">
          <ac:chgData name="Guy Levin" userId="796a6ee1-938f-4754-82f4-44af232fdd3d" providerId="ADAL" clId="{65675048-CCC5-4663-A5ED-1EE0BAA0D74C}" dt="2024-06-10T12:25:06.540" v="24" actId="478"/>
          <ac:spMkLst>
            <pc:docMk/>
            <pc:sldMk cId="1432036717" sldId="299"/>
            <ac:spMk id="26" creationId="{2F0EF0D1-ABFB-119A-65D4-C9554E040AEE}"/>
          </ac:spMkLst>
        </pc:spChg>
      </pc:sldChg>
      <pc:sldChg chg="addSp delSp modSp">
        <pc:chgData name="Guy Levin" userId="796a6ee1-938f-4754-82f4-44af232fdd3d" providerId="ADAL" clId="{65675048-CCC5-4663-A5ED-1EE0BAA0D74C}" dt="2024-06-10T12:21:54.669" v="17" actId="1076"/>
        <pc:sldMkLst>
          <pc:docMk/>
          <pc:sldMk cId="2034325348" sldId="1341"/>
        </pc:sldMkLst>
        <pc:spChg chg="del">
          <ac:chgData name="Guy Levin" userId="796a6ee1-938f-4754-82f4-44af232fdd3d" providerId="ADAL" clId="{65675048-CCC5-4663-A5ED-1EE0BAA0D74C}" dt="2024-05-28T08:25:06.213" v="5" actId="478"/>
          <ac:spMkLst>
            <pc:docMk/>
            <pc:sldMk cId="2034325348" sldId="1341"/>
            <ac:spMk id="2" creationId="{55E46FE8-192C-4312-9422-40CB7E225B57}"/>
          </ac:spMkLst>
        </pc:spChg>
        <pc:spChg chg="del">
          <ac:chgData name="Guy Levin" userId="796a6ee1-938f-4754-82f4-44af232fdd3d" providerId="ADAL" clId="{65675048-CCC5-4663-A5ED-1EE0BAA0D74C}" dt="2024-05-28T08:25:02.940" v="4" actId="478"/>
          <ac:spMkLst>
            <pc:docMk/>
            <pc:sldMk cId="2034325348" sldId="1341"/>
            <ac:spMk id="3" creationId="{165C13E4-BA30-EEEC-9915-48143670ED7A}"/>
          </ac:spMkLst>
        </pc:spChg>
        <pc:spChg chg="mod">
          <ac:chgData name="Guy Levin" userId="796a6ee1-938f-4754-82f4-44af232fdd3d" providerId="ADAL" clId="{65675048-CCC5-4663-A5ED-1EE0BAA0D74C}" dt="2024-06-10T12:21:54.669" v="17" actId="1076"/>
          <ac:spMkLst>
            <pc:docMk/>
            <pc:sldMk cId="2034325348" sldId="1341"/>
            <ac:spMk id="6" creationId="{33CB28F7-7461-3EF5-B9B7-3105B0B2206D}"/>
          </ac:spMkLst>
        </pc:spChg>
        <pc:spChg chg="mod">
          <ac:chgData name="Guy Levin" userId="796a6ee1-938f-4754-82f4-44af232fdd3d" providerId="ADAL" clId="{65675048-CCC5-4663-A5ED-1EE0BAA0D74C}" dt="2024-06-10T12:21:54.669" v="17" actId="1076"/>
          <ac:spMkLst>
            <pc:docMk/>
            <pc:sldMk cId="2034325348" sldId="1341"/>
            <ac:spMk id="7" creationId="{CC2CA53A-FD0B-4E93-A8B1-720ED9487CEF}"/>
          </ac:spMkLst>
        </pc:spChg>
        <pc:spChg chg="mod">
          <ac:chgData name="Guy Levin" userId="796a6ee1-938f-4754-82f4-44af232fdd3d" providerId="ADAL" clId="{65675048-CCC5-4663-A5ED-1EE0BAA0D74C}" dt="2024-06-10T12:21:54.669" v="17" actId="1076"/>
          <ac:spMkLst>
            <pc:docMk/>
            <pc:sldMk cId="2034325348" sldId="1341"/>
            <ac:spMk id="8" creationId="{71718261-F870-405A-818B-40CA1C0E0621}"/>
          </ac:spMkLst>
        </pc:spChg>
        <pc:spChg chg="mod">
          <ac:chgData name="Guy Levin" userId="796a6ee1-938f-4754-82f4-44af232fdd3d" providerId="ADAL" clId="{65675048-CCC5-4663-A5ED-1EE0BAA0D74C}" dt="2024-06-10T12:21:54.669" v="17" actId="1076"/>
          <ac:spMkLst>
            <pc:docMk/>
            <pc:sldMk cId="2034325348" sldId="1341"/>
            <ac:spMk id="9" creationId="{F53BD0DB-512E-45F4-BB54-B16EAC518175}"/>
          </ac:spMkLst>
        </pc:spChg>
        <pc:spChg chg="mod">
          <ac:chgData name="Guy Levin" userId="796a6ee1-938f-4754-82f4-44af232fdd3d" providerId="ADAL" clId="{65675048-CCC5-4663-A5ED-1EE0BAA0D74C}" dt="2024-06-10T12:21:54.669" v="17" actId="1076"/>
          <ac:spMkLst>
            <pc:docMk/>
            <pc:sldMk cId="2034325348" sldId="1341"/>
            <ac:spMk id="10" creationId="{92998ABC-1CA5-4925-B230-FA541E090F4D}"/>
          </ac:spMkLst>
        </pc:spChg>
        <pc:spChg chg="mod">
          <ac:chgData name="Guy Levin" userId="796a6ee1-938f-4754-82f4-44af232fdd3d" providerId="ADAL" clId="{65675048-CCC5-4663-A5ED-1EE0BAA0D74C}" dt="2024-06-10T12:21:54.669" v="17" actId="1076"/>
          <ac:spMkLst>
            <pc:docMk/>
            <pc:sldMk cId="2034325348" sldId="1341"/>
            <ac:spMk id="11" creationId="{A87B4BDE-161F-4D79-9B7F-E6C5015FE53C}"/>
          </ac:spMkLst>
        </pc:spChg>
        <pc:spChg chg="mod">
          <ac:chgData name="Guy Levin" userId="796a6ee1-938f-4754-82f4-44af232fdd3d" providerId="ADAL" clId="{65675048-CCC5-4663-A5ED-1EE0BAA0D74C}" dt="2024-06-10T12:21:54.669" v="17" actId="1076"/>
          <ac:spMkLst>
            <pc:docMk/>
            <pc:sldMk cId="2034325348" sldId="1341"/>
            <ac:spMk id="12" creationId="{AF079CAE-64DD-20D7-62FC-A8309E8F4D39}"/>
          </ac:spMkLst>
        </pc:spChg>
        <pc:spChg chg="del">
          <ac:chgData name="Guy Levin" userId="796a6ee1-938f-4754-82f4-44af232fdd3d" providerId="ADAL" clId="{65675048-CCC5-4663-A5ED-1EE0BAA0D74C}" dt="2024-05-28T08:25:02.940" v="4" actId="478"/>
          <ac:spMkLst>
            <pc:docMk/>
            <pc:sldMk cId="2034325348" sldId="1341"/>
            <ac:spMk id="13" creationId="{7DE3C3B9-D187-A150-9245-94703824B1DD}"/>
          </ac:spMkLst>
        </pc:spChg>
        <pc:spChg chg="del">
          <ac:chgData name="Guy Levin" userId="796a6ee1-938f-4754-82f4-44af232fdd3d" providerId="ADAL" clId="{65675048-CCC5-4663-A5ED-1EE0BAA0D74C}" dt="2024-05-28T08:25:02.940" v="4" actId="478"/>
          <ac:spMkLst>
            <pc:docMk/>
            <pc:sldMk cId="2034325348" sldId="1341"/>
            <ac:spMk id="14" creationId="{45215AE7-9B66-D777-8C8C-7FBC30B43652}"/>
          </ac:spMkLst>
        </pc:spChg>
        <pc:spChg chg="mod">
          <ac:chgData name="Guy Levin" userId="796a6ee1-938f-4754-82f4-44af232fdd3d" providerId="ADAL" clId="{65675048-CCC5-4663-A5ED-1EE0BAA0D74C}" dt="2024-06-10T12:21:54.669" v="17" actId="1076"/>
          <ac:spMkLst>
            <pc:docMk/>
            <pc:sldMk cId="2034325348" sldId="1341"/>
            <ac:spMk id="18" creationId="{351D47F2-9952-490B-8F22-8176E75E4E18}"/>
          </ac:spMkLst>
        </pc:spChg>
        <pc:spChg chg="mod">
          <ac:chgData name="Guy Levin" userId="796a6ee1-938f-4754-82f4-44af232fdd3d" providerId="ADAL" clId="{65675048-CCC5-4663-A5ED-1EE0BAA0D74C}" dt="2024-06-10T12:21:54.669" v="17" actId="1076"/>
          <ac:spMkLst>
            <pc:docMk/>
            <pc:sldMk cId="2034325348" sldId="1341"/>
            <ac:spMk id="19" creationId="{3EAF3056-30CA-4278-A4D3-F03EBD4B6945}"/>
          </ac:spMkLst>
        </pc:spChg>
        <pc:spChg chg="del">
          <ac:chgData name="Guy Levin" userId="796a6ee1-938f-4754-82f4-44af232fdd3d" providerId="ADAL" clId="{65675048-CCC5-4663-A5ED-1EE0BAA0D74C}" dt="2024-05-28T08:25:02.940" v="4" actId="478"/>
          <ac:spMkLst>
            <pc:docMk/>
            <pc:sldMk cId="2034325348" sldId="1341"/>
            <ac:spMk id="27" creationId="{CFBCC9AD-A44C-4320-A224-5A980C2F45AE}"/>
          </ac:spMkLst>
        </pc:spChg>
        <pc:spChg chg="mod">
          <ac:chgData name="Guy Levin" userId="796a6ee1-938f-4754-82f4-44af232fdd3d" providerId="ADAL" clId="{65675048-CCC5-4663-A5ED-1EE0BAA0D74C}" dt="2024-06-10T12:21:54.669" v="17" actId="1076"/>
          <ac:spMkLst>
            <pc:docMk/>
            <pc:sldMk cId="2034325348" sldId="1341"/>
            <ac:spMk id="32" creationId="{4E08334C-5551-4F10-B8D2-414AF554C9CF}"/>
          </ac:spMkLst>
        </pc:spChg>
        <pc:spChg chg="mod">
          <ac:chgData name="Guy Levin" userId="796a6ee1-938f-4754-82f4-44af232fdd3d" providerId="ADAL" clId="{65675048-CCC5-4663-A5ED-1EE0BAA0D74C}" dt="2024-06-10T12:21:54.669" v="17" actId="1076"/>
          <ac:spMkLst>
            <pc:docMk/>
            <pc:sldMk cId="2034325348" sldId="1341"/>
            <ac:spMk id="39" creationId="{442F91BD-7E58-4516-A0E5-B1741BB1CD70}"/>
          </ac:spMkLst>
        </pc:spChg>
        <pc:spChg chg="add del mod">
          <ac:chgData name="Guy Levin" userId="796a6ee1-938f-4754-82f4-44af232fdd3d" providerId="ADAL" clId="{65675048-CCC5-4663-A5ED-1EE0BAA0D74C}" dt="2024-06-10T12:21:45.788" v="16" actId="478"/>
          <ac:spMkLst>
            <pc:docMk/>
            <pc:sldMk cId="2034325348" sldId="1341"/>
            <ac:spMk id="42" creationId="{F54F0CF5-7E95-9CF3-D830-D6C8FE1DDA12}"/>
          </ac:spMkLst>
        </pc:spChg>
        <pc:spChg chg="mod">
          <ac:chgData name="Guy Levin" userId="796a6ee1-938f-4754-82f4-44af232fdd3d" providerId="ADAL" clId="{65675048-CCC5-4663-A5ED-1EE0BAA0D74C}" dt="2024-06-10T12:21:54.669" v="17" actId="1076"/>
          <ac:spMkLst>
            <pc:docMk/>
            <pc:sldMk cId="2034325348" sldId="1341"/>
            <ac:spMk id="43" creationId="{C48E2339-A1DD-771A-80C7-9940FC2FABB5}"/>
          </ac:spMkLst>
        </pc:spChg>
        <pc:spChg chg="mod">
          <ac:chgData name="Guy Levin" userId="796a6ee1-938f-4754-82f4-44af232fdd3d" providerId="ADAL" clId="{65675048-CCC5-4663-A5ED-1EE0BAA0D74C}" dt="2024-06-10T12:21:54.669" v="17" actId="1076"/>
          <ac:spMkLst>
            <pc:docMk/>
            <pc:sldMk cId="2034325348" sldId="1341"/>
            <ac:spMk id="44" creationId="{90CF2406-3037-9C9C-AF1E-DE7FA3E90D61}"/>
          </ac:spMkLst>
        </pc:spChg>
        <pc:spChg chg="mod">
          <ac:chgData name="Guy Levin" userId="796a6ee1-938f-4754-82f4-44af232fdd3d" providerId="ADAL" clId="{65675048-CCC5-4663-A5ED-1EE0BAA0D74C}" dt="2024-06-10T12:21:54.669" v="17" actId="1076"/>
          <ac:spMkLst>
            <pc:docMk/>
            <pc:sldMk cId="2034325348" sldId="1341"/>
            <ac:spMk id="45" creationId="{D36347BB-CBDC-25D6-7DF2-50711EC7F98E}"/>
          </ac:spMkLst>
        </pc:spChg>
        <pc:spChg chg="mod">
          <ac:chgData name="Guy Levin" userId="796a6ee1-938f-4754-82f4-44af232fdd3d" providerId="ADAL" clId="{65675048-CCC5-4663-A5ED-1EE0BAA0D74C}" dt="2024-06-10T12:21:54.669" v="17" actId="1076"/>
          <ac:spMkLst>
            <pc:docMk/>
            <pc:sldMk cId="2034325348" sldId="1341"/>
            <ac:spMk id="46" creationId="{08DD1927-D977-D767-A09F-140F79C784B0}"/>
          </ac:spMkLst>
        </pc:spChg>
        <pc:spChg chg="mod">
          <ac:chgData name="Guy Levin" userId="796a6ee1-938f-4754-82f4-44af232fdd3d" providerId="ADAL" clId="{65675048-CCC5-4663-A5ED-1EE0BAA0D74C}" dt="2024-06-10T12:21:54.669" v="17" actId="1076"/>
          <ac:spMkLst>
            <pc:docMk/>
            <pc:sldMk cId="2034325348" sldId="1341"/>
            <ac:spMk id="47" creationId="{CF8A812E-FB7B-D64B-A87E-71041EBFC7E8}"/>
          </ac:spMkLst>
        </pc:spChg>
        <pc:spChg chg="mod">
          <ac:chgData name="Guy Levin" userId="796a6ee1-938f-4754-82f4-44af232fdd3d" providerId="ADAL" clId="{65675048-CCC5-4663-A5ED-1EE0BAA0D74C}" dt="2024-06-10T12:21:54.669" v="17" actId="1076"/>
          <ac:spMkLst>
            <pc:docMk/>
            <pc:sldMk cId="2034325348" sldId="1341"/>
            <ac:spMk id="48" creationId="{DA840B66-9B47-8EA6-9183-B6D11B2648B3}"/>
          </ac:spMkLst>
        </pc:spChg>
        <pc:spChg chg="del">
          <ac:chgData name="Guy Levin" userId="796a6ee1-938f-4754-82f4-44af232fdd3d" providerId="ADAL" clId="{65675048-CCC5-4663-A5ED-1EE0BAA0D74C}" dt="2024-05-28T08:24:56.670" v="3" actId="478"/>
          <ac:spMkLst>
            <pc:docMk/>
            <pc:sldMk cId="2034325348" sldId="1341"/>
            <ac:spMk id="49" creationId="{E7741978-D8C9-2318-5BF5-1DBF5E6B8D0A}"/>
          </ac:spMkLst>
        </pc:spChg>
        <pc:spChg chg="del">
          <ac:chgData name="Guy Levin" userId="796a6ee1-938f-4754-82f4-44af232fdd3d" providerId="ADAL" clId="{65675048-CCC5-4663-A5ED-1EE0BAA0D74C}" dt="2024-05-28T08:25:02.940" v="4" actId="478"/>
          <ac:spMkLst>
            <pc:docMk/>
            <pc:sldMk cId="2034325348" sldId="1341"/>
            <ac:spMk id="50" creationId="{61E5856D-B67D-8DE6-EBDC-E066CE75D44B}"/>
          </ac:spMkLst>
        </pc:spChg>
        <pc:spChg chg="del">
          <ac:chgData name="Guy Levin" userId="796a6ee1-938f-4754-82f4-44af232fdd3d" providerId="ADAL" clId="{65675048-CCC5-4663-A5ED-1EE0BAA0D74C}" dt="2024-05-28T08:25:02.940" v="4" actId="478"/>
          <ac:spMkLst>
            <pc:docMk/>
            <pc:sldMk cId="2034325348" sldId="1341"/>
            <ac:spMk id="51" creationId="{AB10EBB5-A46F-7696-9F1A-887F9817DBA5}"/>
          </ac:spMkLst>
        </pc:spChg>
        <pc:spChg chg="del">
          <ac:chgData name="Guy Levin" userId="796a6ee1-938f-4754-82f4-44af232fdd3d" providerId="ADAL" clId="{65675048-CCC5-4663-A5ED-1EE0BAA0D74C}" dt="2024-05-28T08:25:02.940" v="4" actId="478"/>
          <ac:spMkLst>
            <pc:docMk/>
            <pc:sldMk cId="2034325348" sldId="1341"/>
            <ac:spMk id="52" creationId="{56642583-FDEC-457F-5062-C68A665985C6}"/>
          </ac:spMkLst>
        </pc:spChg>
        <pc:spChg chg="del">
          <ac:chgData name="Guy Levin" userId="796a6ee1-938f-4754-82f4-44af232fdd3d" providerId="ADAL" clId="{65675048-CCC5-4663-A5ED-1EE0BAA0D74C}" dt="2024-05-28T08:25:02.940" v="4" actId="478"/>
          <ac:spMkLst>
            <pc:docMk/>
            <pc:sldMk cId="2034325348" sldId="1341"/>
            <ac:spMk id="53" creationId="{3C8F68FA-E444-0ECD-0207-B9E3B00412A4}"/>
          </ac:spMkLst>
        </pc:spChg>
        <pc:spChg chg="del">
          <ac:chgData name="Guy Levin" userId="796a6ee1-938f-4754-82f4-44af232fdd3d" providerId="ADAL" clId="{65675048-CCC5-4663-A5ED-1EE0BAA0D74C}" dt="2024-05-28T08:24:56.670" v="3" actId="478"/>
          <ac:spMkLst>
            <pc:docMk/>
            <pc:sldMk cId="2034325348" sldId="1341"/>
            <ac:spMk id="54" creationId="{2286ECCD-B173-3DFA-4B20-67505863486A}"/>
          </ac:spMkLst>
        </pc:spChg>
        <pc:spChg chg="mod">
          <ac:chgData name="Guy Levin" userId="796a6ee1-938f-4754-82f4-44af232fdd3d" providerId="ADAL" clId="{65675048-CCC5-4663-A5ED-1EE0BAA0D74C}" dt="2024-06-10T12:21:54.669" v="17" actId="1076"/>
          <ac:spMkLst>
            <pc:docMk/>
            <pc:sldMk cId="2034325348" sldId="1341"/>
            <ac:spMk id="55" creationId="{18D0CA16-79D7-50D2-ACA1-12655DCE9869}"/>
          </ac:spMkLst>
        </pc:spChg>
        <pc:spChg chg="mod">
          <ac:chgData name="Guy Levin" userId="796a6ee1-938f-4754-82f4-44af232fdd3d" providerId="ADAL" clId="{65675048-CCC5-4663-A5ED-1EE0BAA0D74C}" dt="2024-06-10T12:21:54.669" v="17" actId="1076"/>
          <ac:spMkLst>
            <pc:docMk/>
            <pc:sldMk cId="2034325348" sldId="1341"/>
            <ac:spMk id="61" creationId="{96332946-C41D-02AC-6D37-BE3997BC9C4A}"/>
          </ac:spMkLst>
        </pc:spChg>
        <pc:spChg chg="del">
          <ac:chgData name="Guy Levin" userId="796a6ee1-938f-4754-82f4-44af232fdd3d" providerId="ADAL" clId="{65675048-CCC5-4663-A5ED-1EE0BAA0D74C}" dt="2024-05-28T08:25:09.671" v="6" actId="478"/>
          <ac:spMkLst>
            <pc:docMk/>
            <pc:sldMk cId="2034325348" sldId="1341"/>
            <ac:spMk id="65" creationId="{18CA557C-D93A-5EE2-A05D-7D7565907F58}"/>
          </ac:spMkLst>
        </pc:spChg>
        <pc:grpChg chg="del">
          <ac:chgData name="Guy Levin" userId="796a6ee1-938f-4754-82f4-44af232fdd3d" providerId="ADAL" clId="{65675048-CCC5-4663-A5ED-1EE0BAA0D74C}" dt="2024-05-28T08:25:02.940" v="4" actId="478"/>
          <ac:grpSpMkLst>
            <pc:docMk/>
            <pc:sldMk cId="2034325348" sldId="1341"/>
            <ac:grpSpMk id="29" creationId="{CC4D41E3-3319-4983-A208-66D0FC1AB5AB}"/>
          </ac:grpSpMkLst>
        </pc:grpChg>
        <pc:graphicFrameChg chg="mod">
          <ac:chgData name="Guy Levin" userId="796a6ee1-938f-4754-82f4-44af232fdd3d" providerId="ADAL" clId="{65675048-CCC5-4663-A5ED-1EE0BAA0D74C}" dt="2024-06-10T12:21:54.669" v="17" actId="1076"/>
          <ac:graphicFrameMkLst>
            <pc:docMk/>
            <pc:sldMk cId="2034325348" sldId="1341"/>
            <ac:graphicFrameMk id="24" creationId="{7A4B8413-4EA1-419B-B015-CE81E9A436DF}"/>
          </ac:graphicFrameMkLst>
        </pc:graphicFrameChg>
        <pc:graphicFrameChg chg="mod">
          <ac:chgData name="Guy Levin" userId="796a6ee1-938f-4754-82f4-44af232fdd3d" providerId="ADAL" clId="{65675048-CCC5-4663-A5ED-1EE0BAA0D74C}" dt="2024-06-10T12:21:54.669" v="17" actId="1076"/>
          <ac:graphicFrameMkLst>
            <pc:docMk/>
            <pc:sldMk cId="2034325348" sldId="1341"/>
            <ac:graphicFrameMk id="25" creationId="{D527C7FC-D266-464D-AC00-9E823F3D3132}"/>
          </ac:graphicFrameMkLst>
        </pc:graphicFrameChg>
        <pc:graphicFrameChg chg="del mod">
          <ac:chgData name="Guy Levin" userId="796a6ee1-938f-4754-82f4-44af232fdd3d" providerId="ADAL" clId="{65675048-CCC5-4663-A5ED-1EE0BAA0D74C}" dt="2024-05-28T08:25:02.940" v="4" actId="478"/>
          <ac:graphicFrameMkLst>
            <pc:docMk/>
            <pc:sldMk cId="2034325348" sldId="1341"/>
            <ac:graphicFrameMk id="26" creationId="{EDFB0453-9FA4-4A12-AAC9-712B52B6094D}"/>
          </ac:graphicFrameMkLst>
        </pc:graphicFrameChg>
        <pc:graphicFrameChg chg="del">
          <ac:chgData name="Guy Levin" userId="796a6ee1-938f-4754-82f4-44af232fdd3d" providerId="ADAL" clId="{65675048-CCC5-4663-A5ED-1EE0BAA0D74C}" dt="2024-05-28T08:24:54.321" v="2" actId="478"/>
          <ac:graphicFrameMkLst>
            <pc:docMk/>
            <pc:sldMk cId="2034325348" sldId="1341"/>
            <ac:graphicFrameMk id="33" creationId="{FC92DF1C-A388-4E18-A40A-24379A5F7132}"/>
          </ac:graphicFrameMkLst>
        </pc:graphicFrameChg>
        <pc:graphicFrameChg chg="add del mod">
          <ac:chgData name="Guy Levin" userId="796a6ee1-938f-4754-82f4-44af232fdd3d" providerId="ADAL" clId="{65675048-CCC5-4663-A5ED-1EE0BAA0D74C}" dt="2024-06-10T12:21:41.736" v="14" actId="478"/>
          <ac:graphicFrameMkLst>
            <pc:docMk/>
            <pc:sldMk cId="2034325348" sldId="1341"/>
            <ac:graphicFrameMk id="56" creationId="{D15D6FC2-6851-4B2E-847B-99E6A4252B51}"/>
          </ac:graphicFrameMkLst>
        </pc:graphicFrameChg>
        <pc:picChg chg="mod">
          <ac:chgData name="Guy Levin" userId="796a6ee1-938f-4754-82f4-44af232fdd3d" providerId="ADAL" clId="{65675048-CCC5-4663-A5ED-1EE0BAA0D74C}" dt="2024-06-10T12:21:54.669" v="17" actId="1076"/>
          <ac:picMkLst>
            <pc:docMk/>
            <pc:sldMk cId="2034325348" sldId="1341"/>
            <ac:picMk id="4" creationId="{35AB84AC-F5FF-40C7-A759-6AC20D7BDB50}"/>
          </ac:picMkLst>
        </pc:picChg>
        <pc:picChg chg="mod">
          <ac:chgData name="Guy Levin" userId="796a6ee1-938f-4754-82f4-44af232fdd3d" providerId="ADAL" clId="{65675048-CCC5-4663-A5ED-1EE0BAA0D74C}" dt="2024-06-10T12:21:54.669" v="17" actId="1076"/>
          <ac:picMkLst>
            <pc:docMk/>
            <pc:sldMk cId="2034325348" sldId="1341"/>
            <ac:picMk id="5" creationId="{A278E044-1B9A-473A-83C4-1E829CFFA60F}"/>
          </ac:picMkLst>
        </pc:picChg>
        <pc:cxnChg chg="mod">
          <ac:chgData name="Guy Levin" userId="796a6ee1-938f-4754-82f4-44af232fdd3d" providerId="ADAL" clId="{65675048-CCC5-4663-A5ED-1EE0BAA0D74C}" dt="2024-06-10T12:21:54.669" v="17" actId="1076"/>
          <ac:cxnSpMkLst>
            <pc:docMk/>
            <pc:sldMk cId="2034325348" sldId="1341"/>
            <ac:cxnSpMk id="57" creationId="{928D54EA-EE16-194A-C19F-74BE30C7F4FC}"/>
          </ac:cxnSpMkLst>
        </pc:cxnChg>
        <pc:cxnChg chg="mod">
          <ac:chgData name="Guy Levin" userId="796a6ee1-938f-4754-82f4-44af232fdd3d" providerId="ADAL" clId="{65675048-CCC5-4663-A5ED-1EE0BAA0D74C}" dt="2024-06-10T12:21:54.669" v="17" actId="1076"/>
          <ac:cxnSpMkLst>
            <pc:docMk/>
            <pc:sldMk cId="2034325348" sldId="1341"/>
            <ac:cxnSpMk id="59" creationId="{5EB2AD94-AF6F-C711-1083-456F64ED4610}"/>
          </ac:cxnSpMkLst>
        </pc:cxnChg>
        <pc:cxnChg chg="mod">
          <ac:chgData name="Guy Levin" userId="796a6ee1-938f-4754-82f4-44af232fdd3d" providerId="ADAL" clId="{65675048-CCC5-4663-A5ED-1EE0BAA0D74C}" dt="2024-06-10T12:21:54.669" v="17" actId="1076"/>
          <ac:cxnSpMkLst>
            <pc:docMk/>
            <pc:sldMk cId="2034325348" sldId="1341"/>
            <ac:cxnSpMk id="60" creationId="{BB9922AD-D9C8-62A2-B090-E7A09F1482A3}"/>
          </ac:cxnSpMkLst>
        </pc:cxnChg>
        <pc:cxnChg chg="mod">
          <ac:chgData name="Guy Levin" userId="796a6ee1-938f-4754-82f4-44af232fdd3d" providerId="ADAL" clId="{65675048-CCC5-4663-A5ED-1EE0BAA0D74C}" dt="2024-06-10T12:21:54.669" v="17" actId="1076"/>
          <ac:cxnSpMkLst>
            <pc:docMk/>
            <pc:sldMk cId="2034325348" sldId="1341"/>
            <ac:cxnSpMk id="62" creationId="{808387B6-212A-3E56-0137-87339CE337FB}"/>
          </ac:cxnSpMkLst>
        </pc:cxnChg>
        <pc:cxnChg chg="mod">
          <ac:chgData name="Guy Levin" userId="796a6ee1-938f-4754-82f4-44af232fdd3d" providerId="ADAL" clId="{65675048-CCC5-4663-A5ED-1EE0BAA0D74C}" dt="2024-06-10T12:21:54.669" v="17" actId="1076"/>
          <ac:cxnSpMkLst>
            <pc:docMk/>
            <pc:sldMk cId="2034325348" sldId="1341"/>
            <ac:cxnSpMk id="63" creationId="{871009F6-5DD7-242F-8F13-7C84975816DC}"/>
          </ac:cxnSpMkLst>
        </pc:cxnChg>
        <pc:cxnChg chg="mod">
          <ac:chgData name="Guy Levin" userId="796a6ee1-938f-4754-82f4-44af232fdd3d" providerId="ADAL" clId="{65675048-CCC5-4663-A5ED-1EE0BAA0D74C}" dt="2024-06-10T12:21:54.669" v="17" actId="1076"/>
          <ac:cxnSpMkLst>
            <pc:docMk/>
            <pc:sldMk cId="2034325348" sldId="1341"/>
            <ac:cxnSpMk id="64" creationId="{CB172AF9-73CE-263C-FBEC-C06E401178A2}"/>
          </ac:cxnSpMkLst>
        </pc:cxn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28B8E186-0FD4-4CC8-B64F-C6AA0C61C1E7}" type="datetimeFigureOut">
              <a:rPr lang="en-IL" smtClean="0"/>
              <a:t>19/09/2024</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37091357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8B8E186-0FD4-4CC8-B64F-C6AA0C61C1E7}" type="datetimeFigureOut">
              <a:rPr lang="en-IL" smtClean="0"/>
              <a:t>19/09/2024</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212337280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8B8E186-0FD4-4CC8-B64F-C6AA0C61C1E7}" type="datetimeFigureOut">
              <a:rPr lang="en-IL" smtClean="0"/>
              <a:t>19/09/2024</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115184601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28B8E186-0FD4-4CC8-B64F-C6AA0C61C1E7}" type="datetimeFigureOut">
              <a:rPr lang="en-IL" smtClean="0"/>
              <a:t>19/09/2024</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33127862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28B8E186-0FD4-4CC8-B64F-C6AA0C61C1E7}" type="datetimeFigureOut">
              <a:rPr lang="en-IL" smtClean="0"/>
              <a:t>19/09/2024</a:t>
            </a:fld>
            <a:endParaRPr lang="en-IL"/>
          </a:p>
        </p:txBody>
      </p:sp>
      <p:sp>
        <p:nvSpPr>
          <p:cNvPr id="5" name="Footer Placeholder 4"/>
          <p:cNvSpPr>
            <a:spLocks noGrp="1"/>
          </p:cNvSpPr>
          <p:nvPr>
            <p:ph type="ftr" sz="quarter" idx="11"/>
          </p:nvPr>
        </p:nvSpPr>
        <p:spPr/>
        <p:txBody>
          <a:bodyPr/>
          <a:lstStyle/>
          <a:p>
            <a:endParaRPr lang="en-IL"/>
          </a:p>
        </p:txBody>
      </p:sp>
      <p:sp>
        <p:nvSpPr>
          <p:cNvPr id="6" name="Slide Number Placeholder 5"/>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62078457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28B8E186-0FD4-4CC8-B64F-C6AA0C61C1E7}" type="datetimeFigureOut">
              <a:rPr lang="en-IL" smtClean="0"/>
              <a:t>19/09/2024</a:t>
            </a:fld>
            <a:endParaRPr lang="en-IL"/>
          </a:p>
        </p:txBody>
      </p:sp>
      <p:sp>
        <p:nvSpPr>
          <p:cNvPr id="6" name="Footer Placeholder 5"/>
          <p:cNvSpPr>
            <a:spLocks noGrp="1"/>
          </p:cNvSpPr>
          <p:nvPr>
            <p:ph type="ftr" sz="quarter" idx="11"/>
          </p:nvPr>
        </p:nvSpPr>
        <p:spPr/>
        <p:txBody>
          <a:bodyPr/>
          <a:lstStyle/>
          <a:p>
            <a:endParaRPr lang="en-IL"/>
          </a:p>
        </p:txBody>
      </p:sp>
      <p:sp>
        <p:nvSpPr>
          <p:cNvPr id="7" name="Slide Number Placeholder 6"/>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11643413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618442"/>
            <a:ext cx="2901255"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618442"/>
            <a:ext cx="2915543" cy="5322183"/>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28B8E186-0FD4-4CC8-B64F-C6AA0C61C1E7}" type="datetimeFigureOut">
              <a:rPr lang="en-IL" smtClean="0"/>
              <a:t>19/09/2024</a:t>
            </a:fld>
            <a:endParaRPr lang="en-IL"/>
          </a:p>
        </p:txBody>
      </p:sp>
      <p:sp>
        <p:nvSpPr>
          <p:cNvPr id="8" name="Footer Placeholder 7"/>
          <p:cNvSpPr>
            <a:spLocks noGrp="1"/>
          </p:cNvSpPr>
          <p:nvPr>
            <p:ph type="ftr" sz="quarter" idx="11"/>
          </p:nvPr>
        </p:nvSpPr>
        <p:spPr/>
        <p:txBody>
          <a:bodyPr/>
          <a:lstStyle/>
          <a:p>
            <a:endParaRPr lang="en-IL"/>
          </a:p>
        </p:txBody>
      </p:sp>
      <p:sp>
        <p:nvSpPr>
          <p:cNvPr id="9" name="Slide Number Placeholder 8"/>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58554815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28B8E186-0FD4-4CC8-B64F-C6AA0C61C1E7}" type="datetimeFigureOut">
              <a:rPr lang="en-IL" smtClean="0"/>
              <a:t>19/09/2024</a:t>
            </a:fld>
            <a:endParaRPr lang="en-IL"/>
          </a:p>
        </p:txBody>
      </p:sp>
      <p:sp>
        <p:nvSpPr>
          <p:cNvPr id="4" name="Footer Placeholder 3"/>
          <p:cNvSpPr>
            <a:spLocks noGrp="1"/>
          </p:cNvSpPr>
          <p:nvPr>
            <p:ph type="ftr" sz="quarter" idx="11"/>
          </p:nvPr>
        </p:nvSpPr>
        <p:spPr/>
        <p:txBody>
          <a:bodyPr/>
          <a:lstStyle/>
          <a:p>
            <a:endParaRPr lang="en-IL"/>
          </a:p>
        </p:txBody>
      </p:sp>
      <p:sp>
        <p:nvSpPr>
          <p:cNvPr id="5" name="Slide Number Placeholder 4"/>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125507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8B8E186-0FD4-4CC8-B64F-C6AA0C61C1E7}" type="datetimeFigureOut">
              <a:rPr lang="en-IL" smtClean="0"/>
              <a:t>19/09/2024</a:t>
            </a:fld>
            <a:endParaRPr lang="en-IL"/>
          </a:p>
        </p:txBody>
      </p:sp>
      <p:sp>
        <p:nvSpPr>
          <p:cNvPr id="3" name="Footer Placeholder 2"/>
          <p:cNvSpPr>
            <a:spLocks noGrp="1"/>
          </p:cNvSpPr>
          <p:nvPr>
            <p:ph type="ftr" sz="quarter" idx="11"/>
          </p:nvPr>
        </p:nvSpPr>
        <p:spPr/>
        <p:txBody>
          <a:bodyPr/>
          <a:lstStyle/>
          <a:p>
            <a:endParaRPr lang="en-IL"/>
          </a:p>
        </p:txBody>
      </p:sp>
      <p:sp>
        <p:nvSpPr>
          <p:cNvPr id="4" name="Slide Number Placeholder 3"/>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159952398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28B8E186-0FD4-4CC8-B64F-C6AA0C61C1E7}" type="datetimeFigureOut">
              <a:rPr lang="en-IL" smtClean="0"/>
              <a:t>19/09/2024</a:t>
            </a:fld>
            <a:endParaRPr lang="en-IL"/>
          </a:p>
        </p:txBody>
      </p:sp>
      <p:sp>
        <p:nvSpPr>
          <p:cNvPr id="6" name="Footer Placeholder 5"/>
          <p:cNvSpPr>
            <a:spLocks noGrp="1"/>
          </p:cNvSpPr>
          <p:nvPr>
            <p:ph type="ftr" sz="quarter" idx="11"/>
          </p:nvPr>
        </p:nvSpPr>
        <p:spPr/>
        <p:txBody>
          <a:bodyPr/>
          <a:lstStyle/>
          <a:p>
            <a:endParaRPr lang="en-IL"/>
          </a:p>
        </p:txBody>
      </p:sp>
      <p:sp>
        <p:nvSpPr>
          <p:cNvPr id="7" name="Slide Number Placeholder 6"/>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189181194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28B8E186-0FD4-4CC8-B64F-C6AA0C61C1E7}" type="datetimeFigureOut">
              <a:rPr lang="en-IL" smtClean="0"/>
              <a:t>19/09/2024</a:t>
            </a:fld>
            <a:endParaRPr lang="en-IL"/>
          </a:p>
        </p:txBody>
      </p:sp>
      <p:sp>
        <p:nvSpPr>
          <p:cNvPr id="6" name="Footer Placeholder 5"/>
          <p:cNvSpPr>
            <a:spLocks noGrp="1"/>
          </p:cNvSpPr>
          <p:nvPr>
            <p:ph type="ftr" sz="quarter" idx="11"/>
          </p:nvPr>
        </p:nvSpPr>
        <p:spPr/>
        <p:txBody>
          <a:bodyPr/>
          <a:lstStyle/>
          <a:p>
            <a:endParaRPr lang="en-IL"/>
          </a:p>
        </p:txBody>
      </p:sp>
      <p:sp>
        <p:nvSpPr>
          <p:cNvPr id="7" name="Slide Number Placeholder 6"/>
          <p:cNvSpPr>
            <a:spLocks noGrp="1"/>
          </p:cNvSpPr>
          <p:nvPr>
            <p:ph type="sldNum" sz="quarter" idx="12"/>
          </p:nvPr>
        </p:nvSpPr>
        <p:spPr/>
        <p:txBody>
          <a:bodyPr/>
          <a:lstStyle/>
          <a:p>
            <a:fld id="{654C7315-B3D0-4FA9-A887-5262B5CB6B01}" type="slidenum">
              <a:rPr lang="en-IL" smtClean="0"/>
              <a:t>‹#›</a:t>
            </a:fld>
            <a:endParaRPr lang="en-IL"/>
          </a:p>
        </p:txBody>
      </p:sp>
    </p:spTree>
    <p:extLst>
      <p:ext uri="{BB962C8B-B14F-4D97-AF65-F5344CB8AC3E}">
        <p14:creationId xmlns:p14="http://schemas.microsoft.com/office/powerpoint/2010/main" val="31554189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28B8E186-0FD4-4CC8-B64F-C6AA0C61C1E7}" type="datetimeFigureOut">
              <a:rPr lang="en-IL" smtClean="0"/>
              <a:t>19/09/2024</a:t>
            </a:fld>
            <a:endParaRPr lang="en-IL"/>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IL"/>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654C7315-B3D0-4FA9-A887-5262B5CB6B01}" type="slidenum">
              <a:rPr lang="en-IL" smtClean="0"/>
              <a:t>‹#›</a:t>
            </a:fld>
            <a:endParaRPr lang="en-IL"/>
          </a:p>
        </p:txBody>
      </p:sp>
    </p:spTree>
    <p:extLst>
      <p:ext uri="{BB962C8B-B14F-4D97-AF65-F5344CB8AC3E}">
        <p14:creationId xmlns:p14="http://schemas.microsoft.com/office/powerpoint/2010/main" val="162820997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ACBB3B89-5123-454C-AF88-BB167C0CD657}"/>
              </a:ext>
            </a:extLst>
          </p:cNvPr>
          <p:cNvGrpSpPr/>
          <p:nvPr/>
        </p:nvGrpSpPr>
        <p:grpSpPr>
          <a:xfrm>
            <a:off x="1244810" y="4176032"/>
            <a:ext cx="4368380" cy="2520444"/>
            <a:chOff x="1160919" y="4998424"/>
            <a:chExt cx="4368380" cy="2520444"/>
          </a:xfrm>
        </p:grpSpPr>
        <p:sp>
          <p:nvSpPr>
            <p:cNvPr id="20" name="Rectangle 19">
              <a:extLst>
                <a:ext uri="{FF2B5EF4-FFF2-40B4-BE49-F238E27FC236}">
                  <a16:creationId xmlns:a16="http://schemas.microsoft.com/office/drawing/2014/main" id="{0B426DB3-ED93-4D89-BC1F-FE379B64526C}"/>
                </a:ext>
              </a:extLst>
            </p:cNvPr>
            <p:cNvSpPr/>
            <p:nvPr/>
          </p:nvSpPr>
          <p:spPr>
            <a:xfrm>
              <a:off x="1160919" y="4998424"/>
              <a:ext cx="4368380" cy="2520444"/>
            </a:xfrm>
            <a:prstGeom prst="rect">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L"/>
            </a:p>
          </p:txBody>
        </p:sp>
        <p:grpSp>
          <p:nvGrpSpPr>
            <p:cNvPr id="4" name="Group 3">
              <a:extLst>
                <a:ext uri="{FF2B5EF4-FFF2-40B4-BE49-F238E27FC236}">
                  <a16:creationId xmlns:a16="http://schemas.microsoft.com/office/drawing/2014/main" id="{542FDB23-CFA0-43CC-BC4B-7160CD916438}"/>
                </a:ext>
              </a:extLst>
            </p:cNvPr>
            <p:cNvGrpSpPr/>
            <p:nvPr/>
          </p:nvGrpSpPr>
          <p:grpSpPr>
            <a:xfrm>
              <a:off x="1160919" y="5100881"/>
              <a:ext cx="4368380" cy="2417987"/>
              <a:chOff x="1118394" y="93962"/>
              <a:chExt cx="4368380" cy="2417987"/>
            </a:xfrm>
          </p:grpSpPr>
          <p:grpSp>
            <p:nvGrpSpPr>
              <p:cNvPr id="5" name="Group 4">
                <a:extLst>
                  <a:ext uri="{FF2B5EF4-FFF2-40B4-BE49-F238E27FC236}">
                    <a16:creationId xmlns:a16="http://schemas.microsoft.com/office/drawing/2014/main" id="{5286E609-6389-48A2-9068-165BAEF28ADE}"/>
                  </a:ext>
                </a:extLst>
              </p:cNvPr>
              <p:cNvGrpSpPr/>
              <p:nvPr/>
            </p:nvGrpSpPr>
            <p:grpSpPr>
              <a:xfrm>
                <a:off x="1118394" y="93962"/>
                <a:ext cx="4368380" cy="2417987"/>
                <a:chOff x="1118394" y="93962"/>
                <a:chExt cx="4368380" cy="2417987"/>
              </a:xfrm>
            </p:grpSpPr>
            <p:pic>
              <p:nvPicPr>
                <p:cNvPr id="7" name="Picture 6">
                  <a:extLst>
                    <a:ext uri="{FF2B5EF4-FFF2-40B4-BE49-F238E27FC236}">
                      <a16:creationId xmlns:a16="http://schemas.microsoft.com/office/drawing/2014/main" id="{2833AB49-A20F-4DD1-82E6-0B306333603A}"/>
                    </a:ext>
                  </a:extLst>
                </p:cNvPr>
                <p:cNvPicPr>
                  <a:picLocks noChangeAspect="1"/>
                </p:cNvPicPr>
                <p:nvPr/>
              </p:nvPicPr>
              <p:blipFill rotWithShape="1">
                <a:blip r:embed="rId2"/>
                <a:srcRect l="31843" t="35134" r="17966" b="11233"/>
                <a:stretch/>
              </p:blipFill>
              <p:spPr>
                <a:xfrm>
                  <a:off x="1435172" y="93962"/>
                  <a:ext cx="3918882" cy="2399579"/>
                </a:xfrm>
                <a:prstGeom prst="rect">
                  <a:avLst/>
                </a:prstGeom>
              </p:spPr>
            </p:pic>
            <p:sp>
              <p:nvSpPr>
                <p:cNvPr id="8" name="TextBox 7">
                  <a:extLst>
                    <a:ext uri="{FF2B5EF4-FFF2-40B4-BE49-F238E27FC236}">
                      <a16:creationId xmlns:a16="http://schemas.microsoft.com/office/drawing/2014/main" id="{FCE34CB9-33A9-4389-A972-342410004789}"/>
                    </a:ext>
                  </a:extLst>
                </p:cNvPr>
                <p:cNvSpPr txBox="1"/>
                <p:nvPr/>
              </p:nvSpPr>
              <p:spPr>
                <a:xfrm>
                  <a:off x="1118394" y="242091"/>
                  <a:ext cx="802668" cy="338554"/>
                </a:xfrm>
                <a:prstGeom prst="rect">
                  <a:avLst/>
                </a:prstGeom>
                <a:solidFill>
                  <a:srgbClr val="F2F2F2"/>
                </a:solidFill>
              </p:spPr>
              <p:txBody>
                <a:bodyPr wrap="square" rtlCol="0">
                  <a:spAutoFit/>
                </a:bodyPr>
                <a:lstStyle/>
                <a:p>
                  <a:pPr algn="ctr"/>
                  <a:r>
                    <a:rPr lang="en-GB" sz="800"/>
                    <a:t>SOSG fluorescence</a:t>
                  </a:r>
                </a:p>
              </p:txBody>
            </p:sp>
            <p:sp>
              <p:nvSpPr>
                <p:cNvPr id="9" name="TextBox 8">
                  <a:extLst>
                    <a:ext uri="{FF2B5EF4-FFF2-40B4-BE49-F238E27FC236}">
                      <a16:creationId xmlns:a16="http://schemas.microsoft.com/office/drawing/2014/main" id="{43331137-9028-439D-A772-485B821AF22B}"/>
                    </a:ext>
                  </a:extLst>
                </p:cNvPr>
                <p:cNvSpPr txBox="1"/>
                <p:nvPr/>
              </p:nvSpPr>
              <p:spPr>
                <a:xfrm>
                  <a:off x="1118394" y="559497"/>
                  <a:ext cx="802668" cy="338554"/>
                </a:xfrm>
                <a:prstGeom prst="rect">
                  <a:avLst/>
                </a:prstGeom>
                <a:solidFill>
                  <a:srgbClr val="F2F2F2"/>
                </a:solidFill>
              </p:spPr>
              <p:txBody>
                <a:bodyPr wrap="square" rtlCol="0">
                  <a:spAutoFit/>
                </a:bodyPr>
                <a:lstStyle/>
                <a:p>
                  <a:pPr algn="ctr"/>
                  <a:r>
                    <a:rPr lang="en-GB" sz="800"/>
                    <a:t>Chlorophyll fluorescence</a:t>
                  </a:r>
                </a:p>
              </p:txBody>
            </p:sp>
            <p:sp>
              <p:nvSpPr>
                <p:cNvPr id="10" name="TextBox 9">
                  <a:extLst>
                    <a:ext uri="{FF2B5EF4-FFF2-40B4-BE49-F238E27FC236}">
                      <a16:creationId xmlns:a16="http://schemas.microsoft.com/office/drawing/2014/main" id="{F41C6720-CE4D-4407-82B6-A23A8022861D}"/>
                    </a:ext>
                  </a:extLst>
                </p:cNvPr>
                <p:cNvSpPr txBox="1"/>
                <p:nvPr/>
              </p:nvSpPr>
              <p:spPr>
                <a:xfrm>
                  <a:off x="1663105" y="900734"/>
                  <a:ext cx="908203" cy="338554"/>
                </a:xfrm>
                <a:prstGeom prst="rect">
                  <a:avLst/>
                </a:prstGeom>
                <a:solidFill>
                  <a:srgbClr val="F2F2F2"/>
                </a:solidFill>
              </p:spPr>
              <p:txBody>
                <a:bodyPr wrap="square" rtlCol="0">
                  <a:spAutoFit/>
                </a:bodyPr>
                <a:lstStyle/>
                <a:p>
                  <a:pPr algn="ctr"/>
                  <a:r>
                    <a:rPr lang="en-GB" sz="800"/>
                    <a:t>The central plane of the cell</a:t>
                  </a:r>
                </a:p>
              </p:txBody>
            </p:sp>
            <p:sp>
              <p:nvSpPr>
                <p:cNvPr id="11" name="TextBox 10">
                  <a:extLst>
                    <a:ext uri="{FF2B5EF4-FFF2-40B4-BE49-F238E27FC236}">
                      <a16:creationId xmlns:a16="http://schemas.microsoft.com/office/drawing/2014/main" id="{F8E43BA3-54BE-484E-B0E5-BDB5CFDDFDC3}"/>
                    </a:ext>
                  </a:extLst>
                </p:cNvPr>
                <p:cNvSpPr txBox="1"/>
                <p:nvPr/>
              </p:nvSpPr>
              <p:spPr>
                <a:xfrm>
                  <a:off x="2811515" y="930428"/>
                  <a:ext cx="1118195" cy="338554"/>
                </a:xfrm>
                <a:prstGeom prst="rect">
                  <a:avLst/>
                </a:prstGeom>
                <a:solidFill>
                  <a:srgbClr val="F2F2F2"/>
                </a:solidFill>
              </p:spPr>
              <p:txBody>
                <a:bodyPr wrap="square" rtlCol="0">
                  <a:spAutoFit/>
                </a:bodyPr>
                <a:lstStyle/>
                <a:p>
                  <a:pPr algn="ctr"/>
                  <a:r>
                    <a:rPr lang="en-GB" sz="800"/>
                    <a:t>General scheme of the Z-stack: side view</a:t>
                  </a:r>
                </a:p>
              </p:txBody>
            </p:sp>
            <p:sp>
              <p:nvSpPr>
                <p:cNvPr id="12" name="TextBox 11">
                  <a:extLst>
                    <a:ext uri="{FF2B5EF4-FFF2-40B4-BE49-F238E27FC236}">
                      <a16:creationId xmlns:a16="http://schemas.microsoft.com/office/drawing/2014/main" id="{D7C22D5C-E5A5-43E7-B66E-05919CE4CCCF}"/>
                    </a:ext>
                  </a:extLst>
                </p:cNvPr>
                <p:cNvSpPr txBox="1"/>
                <p:nvPr/>
              </p:nvSpPr>
              <p:spPr>
                <a:xfrm>
                  <a:off x="4084972" y="930428"/>
                  <a:ext cx="1118195" cy="338554"/>
                </a:xfrm>
                <a:prstGeom prst="rect">
                  <a:avLst/>
                </a:prstGeom>
                <a:solidFill>
                  <a:srgbClr val="F2F2F2"/>
                </a:solidFill>
              </p:spPr>
              <p:txBody>
                <a:bodyPr wrap="square" rtlCol="0">
                  <a:spAutoFit/>
                </a:bodyPr>
                <a:lstStyle/>
                <a:p>
                  <a:pPr algn="ctr"/>
                  <a:r>
                    <a:rPr lang="en-GB" sz="800"/>
                    <a:t>General scheme of the Z-stack: top view</a:t>
                  </a:r>
                </a:p>
              </p:txBody>
            </p:sp>
            <p:sp>
              <p:nvSpPr>
                <p:cNvPr id="13" name="TextBox 12">
                  <a:extLst>
                    <a:ext uri="{FF2B5EF4-FFF2-40B4-BE49-F238E27FC236}">
                      <a16:creationId xmlns:a16="http://schemas.microsoft.com/office/drawing/2014/main" id="{7E2EBC55-DA4B-4ABE-BC46-854213FC7824}"/>
                    </a:ext>
                  </a:extLst>
                </p:cNvPr>
                <p:cNvSpPr txBox="1"/>
                <p:nvPr/>
              </p:nvSpPr>
              <p:spPr>
                <a:xfrm>
                  <a:off x="1351519" y="2042548"/>
                  <a:ext cx="1161755" cy="461665"/>
                </a:xfrm>
                <a:prstGeom prst="rect">
                  <a:avLst/>
                </a:prstGeom>
                <a:solidFill>
                  <a:srgbClr val="F2F2F2"/>
                </a:solidFill>
              </p:spPr>
              <p:txBody>
                <a:bodyPr wrap="square" rtlCol="0">
                  <a:spAutoFit/>
                </a:bodyPr>
                <a:lstStyle/>
                <a:p>
                  <a:pPr algn="ctr"/>
                  <a:r>
                    <a:rPr lang="en-GB" sz="800"/>
                    <a:t>Merged Z-stack of SOSG and chlorophyll fluorescence</a:t>
                  </a:r>
                </a:p>
              </p:txBody>
            </p:sp>
            <p:sp>
              <p:nvSpPr>
                <p:cNvPr id="14" name="TextBox 13">
                  <a:extLst>
                    <a:ext uri="{FF2B5EF4-FFF2-40B4-BE49-F238E27FC236}">
                      <a16:creationId xmlns:a16="http://schemas.microsoft.com/office/drawing/2014/main" id="{4BE3FBE5-B851-4FCD-AE44-FA901A52418D}"/>
                    </a:ext>
                  </a:extLst>
                </p:cNvPr>
                <p:cNvSpPr txBox="1"/>
                <p:nvPr/>
              </p:nvSpPr>
              <p:spPr>
                <a:xfrm>
                  <a:off x="2489314" y="2041341"/>
                  <a:ext cx="915431" cy="461665"/>
                </a:xfrm>
                <a:prstGeom prst="rect">
                  <a:avLst/>
                </a:prstGeom>
                <a:solidFill>
                  <a:srgbClr val="F2F2F2"/>
                </a:solidFill>
              </p:spPr>
              <p:txBody>
                <a:bodyPr wrap="square" rtlCol="0">
                  <a:spAutoFit/>
                </a:bodyPr>
                <a:lstStyle/>
                <a:p>
                  <a:pPr algn="ctr"/>
                  <a:r>
                    <a:rPr lang="en-GB" sz="800"/>
                    <a:t>Z-stack chlorophyll fluorescence</a:t>
                  </a:r>
                </a:p>
              </p:txBody>
            </p:sp>
            <p:sp>
              <p:nvSpPr>
                <p:cNvPr id="15" name="TextBox 14">
                  <a:extLst>
                    <a:ext uri="{FF2B5EF4-FFF2-40B4-BE49-F238E27FC236}">
                      <a16:creationId xmlns:a16="http://schemas.microsoft.com/office/drawing/2014/main" id="{1263C5DB-6777-4FF4-89B9-D5DA8E051FBE}"/>
                    </a:ext>
                  </a:extLst>
                </p:cNvPr>
                <p:cNvSpPr txBox="1"/>
                <p:nvPr/>
              </p:nvSpPr>
              <p:spPr>
                <a:xfrm>
                  <a:off x="4325019" y="2031718"/>
                  <a:ext cx="1161755" cy="461665"/>
                </a:xfrm>
                <a:prstGeom prst="rect">
                  <a:avLst/>
                </a:prstGeom>
                <a:solidFill>
                  <a:srgbClr val="F2F2F2"/>
                </a:solidFill>
              </p:spPr>
              <p:txBody>
                <a:bodyPr wrap="square" rtlCol="0">
                  <a:spAutoFit/>
                </a:bodyPr>
                <a:lstStyle/>
                <a:p>
                  <a:pPr algn="ctr"/>
                  <a:r>
                    <a:rPr lang="en-GB" sz="800"/>
                    <a:t>Merge of Z-Z-stack SOSG and  chloroplast volume</a:t>
                  </a:r>
                </a:p>
              </p:txBody>
            </p:sp>
            <p:sp>
              <p:nvSpPr>
                <p:cNvPr id="16" name="TextBox 15">
                  <a:extLst>
                    <a:ext uri="{FF2B5EF4-FFF2-40B4-BE49-F238E27FC236}">
                      <a16:creationId xmlns:a16="http://schemas.microsoft.com/office/drawing/2014/main" id="{271F1B38-A87F-400F-87ED-7B59B6F360B3}"/>
                    </a:ext>
                  </a:extLst>
                </p:cNvPr>
                <p:cNvSpPr txBox="1"/>
                <p:nvPr/>
              </p:nvSpPr>
              <p:spPr>
                <a:xfrm>
                  <a:off x="3827660" y="617013"/>
                  <a:ext cx="364633" cy="220230"/>
                </a:xfrm>
                <a:prstGeom prst="rect">
                  <a:avLst/>
                </a:prstGeom>
                <a:solidFill>
                  <a:srgbClr val="F2F2F2"/>
                </a:solidFill>
              </p:spPr>
              <p:txBody>
                <a:bodyPr wrap="square" rtlCol="0">
                  <a:spAutoFit/>
                </a:bodyPr>
                <a:lstStyle/>
                <a:p>
                  <a:pPr algn="ctr"/>
                  <a:r>
                    <a:rPr lang="en-GB" sz="800"/>
                    <a:t>90</a:t>
                  </a:r>
                  <a:r>
                    <a:rPr lang="en-GB" sz="800" baseline="30000"/>
                    <a:t>0</a:t>
                  </a:r>
                </a:p>
              </p:txBody>
            </p:sp>
            <p:sp>
              <p:nvSpPr>
                <p:cNvPr id="17" name="TextBox 16">
                  <a:extLst>
                    <a:ext uri="{FF2B5EF4-FFF2-40B4-BE49-F238E27FC236}">
                      <a16:creationId xmlns:a16="http://schemas.microsoft.com/office/drawing/2014/main" id="{48BDA555-C484-4895-965E-CE08CA977885}"/>
                    </a:ext>
                  </a:extLst>
                </p:cNvPr>
                <p:cNvSpPr txBox="1"/>
                <p:nvPr/>
              </p:nvSpPr>
              <p:spPr>
                <a:xfrm>
                  <a:off x="3354584" y="2050284"/>
                  <a:ext cx="1068212" cy="461665"/>
                </a:xfrm>
                <a:prstGeom prst="rect">
                  <a:avLst/>
                </a:prstGeom>
                <a:solidFill>
                  <a:srgbClr val="F2F2F2"/>
                </a:solidFill>
              </p:spPr>
              <p:txBody>
                <a:bodyPr wrap="square" rtlCol="0">
                  <a:spAutoFit/>
                </a:bodyPr>
                <a:lstStyle/>
                <a:p>
                  <a:pPr algn="ctr"/>
                  <a:r>
                    <a:rPr lang="en-GB" sz="800"/>
                    <a:t>Chloroplast volume based on chlorophyll fluorescence</a:t>
                  </a:r>
                </a:p>
              </p:txBody>
            </p:sp>
          </p:grpSp>
          <p:sp>
            <p:nvSpPr>
              <p:cNvPr id="6" name="TextBox 5">
                <a:extLst>
                  <a:ext uri="{FF2B5EF4-FFF2-40B4-BE49-F238E27FC236}">
                    <a16:creationId xmlns:a16="http://schemas.microsoft.com/office/drawing/2014/main" id="{B57C5348-0BD9-4AB5-AC43-FC40A3D879CF}"/>
                  </a:ext>
                </a:extLst>
              </p:cNvPr>
              <p:cNvSpPr txBox="1"/>
              <p:nvPr/>
            </p:nvSpPr>
            <p:spPr>
              <a:xfrm>
                <a:off x="1372876" y="1188699"/>
                <a:ext cx="174557" cy="195206"/>
              </a:xfrm>
              <a:prstGeom prst="rect">
                <a:avLst/>
              </a:prstGeom>
              <a:solidFill>
                <a:srgbClr val="F2F2F2"/>
              </a:solidFill>
            </p:spPr>
            <p:txBody>
              <a:bodyPr wrap="square" rtlCol="0">
                <a:spAutoFit/>
              </a:bodyPr>
              <a:lstStyle/>
              <a:p>
                <a:pPr algn="ctr"/>
                <a:endParaRPr lang="en-GB" sz="800"/>
              </a:p>
            </p:txBody>
          </p:sp>
        </p:grpSp>
      </p:grpSp>
      <p:pic>
        <p:nvPicPr>
          <p:cNvPr id="18" name="Picture 17" descr="A diagram of a computer&#10;&#10;Description automatically generated">
            <a:extLst>
              <a:ext uri="{FF2B5EF4-FFF2-40B4-BE49-F238E27FC236}">
                <a16:creationId xmlns:a16="http://schemas.microsoft.com/office/drawing/2014/main" id="{51CBEB06-9705-4622-86F2-4CB30E46DBA2}"/>
              </a:ext>
            </a:extLst>
          </p:cNvPr>
          <p:cNvPicPr>
            <a:picLocks noChangeAspect="1"/>
          </p:cNvPicPr>
          <p:nvPr/>
        </p:nvPicPr>
        <p:blipFill>
          <a:blip r:embed="rId3"/>
          <a:stretch>
            <a:fillRect/>
          </a:stretch>
        </p:blipFill>
        <p:spPr>
          <a:xfrm>
            <a:off x="418098" y="365661"/>
            <a:ext cx="6021804" cy="3519722"/>
          </a:xfrm>
          <a:prstGeom prst="rect">
            <a:avLst/>
          </a:prstGeom>
        </p:spPr>
      </p:pic>
      <p:sp>
        <p:nvSpPr>
          <p:cNvPr id="19" name="Isosceles Triangle 18">
            <a:extLst>
              <a:ext uri="{FF2B5EF4-FFF2-40B4-BE49-F238E27FC236}">
                <a16:creationId xmlns:a16="http://schemas.microsoft.com/office/drawing/2014/main" id="{72353A65-9C66-417D-A69D-F1C76564CF76}"/>
              </a:ext>
            </a:extLst>
          </p:cNvPr>
          <p:cNvSpPr/>
          <p:nvPr/>
        </p:nvSpPr>
        <p:spPr>
          <a:xfrm>
            <a:off x="1618426" y="2956840"/>
            <a:ext cx="1227350" cy="1219192"/>
          </a:xfrm>
          <a:prstGeom prst="triangle">
            <a:avLst/>
          </a:prstGeom>
          <a:solidFill>
            <a:schemeClr val="bg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IL"/>
          </a:p>
        </p:txBody>
      </p:sp>
      <p:sp>
        <p:nvSpPr>
          <p:cNvPr id="23" name="TextBox 22">
            <a:extLst>
              <a:ext uri="{FF2B5EF4-FFF2-40B4-BE49-F238E27FC236}">
                <a16:creationId xmlns:a16="http://schemas.microsoft.com/office/drawing/2014/main" id="{8529635B-DB18-497F-98FE-97AD86BC8421}"/>
              </a:ext>
            </a:extLst>
          </p:cNvPr>
          <p:cNvSpPr txBox="1"/>
          <p:nvPr/>
        </p:nvSpPr>
        <p:spPr>
          <a:xfrm>
            <a:off x="418098" y="211772"/>
            <a:ext cx="288862" cy="307777"/>
          </a:xfrm>
          <a:prstGeom prst="rect">
            <a:avLst/>
          </a:prstGeom>
          <a:noFill/>
        </p:spPr>
        <p:txBody>
          <a:bodyPr wrap="none" rtlCol="0">
            <a:spAutoFit/>
          </a:bodyPr>
          <a:lstStyle/>
          <a:p>
            <a:r>
              <a:rPr lang="en-US" sz="1400"/>
              <a:t>A</a:t>
            </a:r>
            <a:endParaRPr lang="en-IL" sz="1400"/>
          </a:p>
        </p:txBody>
      </p:sp>
      <p:sp>
        <p:nvSpPr>
          <p:cNvPr id="24" name="TextBox 23">
            <a:extLst>
              <a:ext uri="{FF2B5EF4-FFF2-40B4-BE49-F238E27FC236}">
                <a16:creationId xmlns:a16="http://schemas.microsoft.com/office/drawing/2014/main" id="{8E07D67A-4D82-4CB3-BF96-215221AB9918}"/>
              </a:ext>
            </a:extLst>
          </p:cNvPr>
          <p:cNvSpPr txBox="1"/>
          <p:nvPr/>
        </p:nvSpPr>
        <p:spPr>
          <a:xfrm>
            <a:off x="1719867" y="211772"/>
            <a:ext cx="288862" cy="307777"/>
          </a:xfrm>
          <a:prstGeom prst="rect">
            <a:avLst/>
          </a:prstGeom>
          <a:noFill/>
        </p:spPr>
        <p:txBody>
          <a:bodyPr wrap="none" rtlCol="0">
            <a:spAutoFit/>
          </a:bodyPr>
          <a:lstStyle/>
          <a:p>
            <a:r>
              <a:rPr lang="en-US" sz="1400"/>
              <a:t>B</a:t>
            </a:r>
            <a:endParaRPr lang="en-IL" sz="1400"/>
          </a:p>
        </p:txBody>
      </p:sp>
      <p:sp>
        <p:nvSpPr>
          <p:cNvPr id="25" name="TextBox 24">
            <a:extLst>
              <a:ext uri="{FF2B5EF4-FFF2-40B4-BE49-F238E27FC236}">
                <a16:creationId xmlns:a16="http://schemas.microsoft.com/office/drawing/2014/main" id="{4433ED7A-4B75-4523-B224-14267FAC5E38}"/>
              </a:ext>
            </a:extLst>
          </p:cNvPr>
          <p:cNvSpPr txBox="1"/>
          <p:nvPr/>
        </p:nvSpPr>
        <p:spPr>
          <a:xfrm>
            <a:off x="5324328" y="1949146"/>
            <a:ext cx="288862" cy="307777"/>
          </a:xfrm>
          <a:prstGeom prst="rect">
            <a:avLst/>
          </a:prstGeom>
          <a:noFill/>
        </p:spPr>
        <p:txBody>
          <a:bodyPr wrap="none" rtlCol="0">
            <a:spAutoFit/>
          </a:bodyPr>
          <a:lstStyle/>
          <a:p>
            <a:r>
              <a:rPr lang="en-US" sz="1400"/>
              <a:t>C</a:t>
            </a:r>
            <a:endParaRPr lang="en-IL" sz="1400"/>
          </a:p>
        </p:txBody>
      </p:sp>
      <p:sp>
        <p:nvSpPr>
          <p:cNvPr id="26" name="TextBox 25">
            <a:extLst>
              <a:ext uri="{FF2B5EF4-FFF2-40B4-BE49-F238E27FC236}">
                <a16:creationId xmlns:a16="http://schemas.microsoft.com/office/drawing/2014/main" id="{27E0F053-A16A-40DA-B44C-BCA98052D86E}"/>
              </a:ext>
            </a:extLst>
          </p:cNvPr>
          <p:cNvSpPr txBox="1"/>
          <p:nvPr/>
        </p:nvSpPr>
        <p:spPr>
          <a:xfrm>
            <a:off x="3767264" y="1949146"/>
            <a:ext cx="295274" cy="307777"/>
          </a:xfrm>
          <a:prstGeom prst="rect">
            <a:avLst/>
          </a:prstGeom>
          <a:noFill/>
        </p:spPr>
        <p:txBody>
          <a:bodyPr wrap="none" rtlCol="0">
            <a:spAutoFit/>
          </a:bodyPr>
          <a:lstStyle/>
          <a:p>
            <a:r>
              <a:rPr lang="en-US" sz="1400"/>
              <a:t>D</a:t>
            </a:r>
            <a:endParaRPr lang="en-IL" sz="1400"/>
          </a:p>
        </p:txBody>
      </p:sp>
      <p:sp>
        <p:nvSpPr>
          <p:cNvPr id="27" name="TextBox 26">
            <a:extLst>
              <a:ext uri="{FF2B5EF4-FFF2-40B4-BE49-F238E27FC236}">
                <a16:creationId xmlns:a16="http://schemas.microsoft.com/office/drawing/2014/main" id="{E48DCAAF-3B57-40F9-ABA7-E752CC336357}"/>
              </a:ext>
            </a:extLst>
          </p:cNvPr>
          <p:cNvSpPr txBox="1"/>
          <p:nvPr/>
        </p:nvSpPr>
        <p:spPr>
          <a:xfrm>
            <a:off x="1948348" y="1949146"/>
            <a:ext cx="272832" cy="307777"/>
          </a:xfrm>
          <a:prstGeom prst="rect">
            <a:avLst/>
          </a:prstGeom>
          <a:noFill/>
        </p:spPr>
        <p:txBody>
          <a:bodyPr wrap="none" rtlCol="0">
            <a:spAutoFit/>
          </a:bodyPr>
          <a:lstStyle/>
          <a:p>
            <a:r>
              <a:rPr lang="en-US" sz="1400"/>
              <a:t>E</a:t>
            </a:r>
            <a:endParaRPr lang="en-IL" sz="1400"/>
          </a:p>
        </p:txBody>
      </p:sp>
    </p:spTree>
    <p:extLst>
      <p:ext uri="{BB962C8B-B14F-4D97-AF65-F5344CB8AC3E}">
        <p14:creationId xmlns:p14="http://schemas.microsoft.com/office/powerpoint/2010/main" val="41025239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20">
            <a:extLst>
              <a:ext uri="{FF2B5EF4-FFF2-40B4-BE49-F238E27FC236}">
                <a16:creationId xmlns:a16="http://schemas.microsoft.com/office/drawing/2014/main" id="{C1F7A105-6E60-4851-B40A-1F5907FF49E0}"/>
              </a:ext>
            </a:extLst>
          </p:cNvPr>
          <p:cNvSpPr txBox="1"/>
          <p:nvPr/>
        </p:nvSpPr>
        <p:spPr>
          <a:xfrm>
            <a:off x="563245" y="3029253"/>
            <a:ext cx="5731510" cy="4676140"/>
          </a:xfrm>
          <a:prstGeom prst="rect">
            <a:avLst/>
          </a:prstGeom>
          <a:noFill/>
        </p:spPr>
        <p:txBody>
          <a:bodyPr wrap="square" rtlCol="0">
            <a:spAutoFit/>
          </a:bodyPr>
          <a:lstStyle/>
          <a:p>
            <a:pPr algn="just">
              <a:lnSpc>
                <a:spcPct val="150000"/>
              </a:lnSpc>
              <a:spcAft>
                <a:spcPts val="0"/>
              </a:spcAft>
            </a:pPr>
            <a:r>
              <a:rPr lang="en-US" sz="1100" b="1" kern="1200" dirty="0">
                <a:solidFill>
                  <a:srgbClr val="000000"/>
                </a:solidFill>
                <a:effectLst/>
                <a:latin typeface="Times New Roman" panose="02020603050405020304" pitchFamily="18" charset="0"/>
                <a:ea typeface="Times New Roman" panose="02020603050405020304" pitchFamily="18" charset="0"/>
              </a:rPr>
              <a:t>Supplementary Figure 4. </a:t>
            </a:r>
            <a:r>
              <a:rPr lang="en-US" sz="1100" kern="1200" baseline="30000" dirty="0">
                <a:solidFill>
                  <a:srgbClr val="000000"/>
                </a:solidFill>
                <a:effectLst/>
                <a:latin typeface="Times New Roman" panose="02020603050405020304" pitchFamily="18" charset="0"/>
                <a:ea typeface="Times New Roman" panose="02020603050405020304" pitchFamily="18" charset="0"/>
              </a:rPr>
              <a:t>1</a:t>
            </a:r>
            <a:r>
              <a:rPr lang="en-US" sz="1100" kern="1200" dirty="0">
                <a:solidFill>
                  <a:srgbClr val="000000"/>
                </a:solidFill>
                <a:effectLst/>
                <a:latin typeface="Times New Roman" panose="02020603050405020304" pitchFamily="18" charset="0"/>
                <a:ea typeface="Times New Roman" panose="02020603050405020304" pitchFamily="18" charset="0"/>
              </a:rPr>
              <a:t>O</a:t>
            </a:r>
            <a:r>
              <a:rPr lang="en-US" sz="1100" kern="1200" baseline="-25000" dirty="0">
                <a:solidFill>
                  <a:srgbClr val="000000"/>
                </a:solidFill>
                <a:effectLst/>
                <a:latin typeface="Times New Roman" panose="02020603050405020304" pitchFamily="18" charset="0"/>
                <a:ea typeface="Times New Roman" panose="02020603050405020304" pitchFamily="18" charset="0"/>
              </a:rPr>
              <a:t>2</a:t>
            </a:r>
            <a:r>
              <a:rPr lang="en-US" sz="1100" kern="1200" dirty="0">
                <a:solidFill>
                  <a:srgbClr val="000000"/>
                </a:solidFill>
                <a:effectLst/>
                <a:latin typeface="Times New Roman" panose="02020603050405020304" pitchFamily="18" charset="0"/>
                <a:ea typeface="Times New Roman" panose="02020603050405020304" pitchFamily="18" charset="0"/>
              </a:rPr>
              <a:t> detection with singlet oxygen sensor green (SOSG) probe workflow.</a:t>
            </a:r>
            <a:r>
              <a:rPr lang="en-US" sz="1200" dirty="0">
                <a:effectLst/>
                <a:latin typeface="Times New Roman" panose="02020603050405020304" pitchFamily="18" charset="0"/>
                <a:ea typeface="Times New Roman" panose="02020603050405020304" pitchFamily="18" charset="0"/>
              </a:rPr>
              <a:t> </a:t>
            </a:r>
            <a:r>
              <a:rPr lang="en-US" sz="1100" b="1" kern="1200" dirty="0">
                <a:solidFill>
                  <a:srgbClr val="000000"/>
                </a:solidFill>
                <a:effectLst/>
                <a:latin typeface="Times New Roman" panose="02020603050405020304" pitchFamily="18" charset="0"/>
                <a:ea typeface="Calibri" panose="020F0502020204030204" pitchFamily="34" charset="0"/>
              </a:rPr>
              <a:t>A) </a:t>
            </a:r>
            <a:r>
              <a:rPr lang="en-US" sz="1100" kern="1200" dirty="0">
                <a:solidFill>
                  <a:srgbClr val="000000"/>
                </a:solidFill>
                <a:effectLst/>
                <a:latin typeface="Times New Roman" panose="02020603050405020304" pitchFamily="18" charset="0"/>
                <a:ea typeface="Calibri" panose="020F0502020204030204" pitchFamily="34" charset="0"/>
              </a:rPr>
              <a:t>SOSG was introduced to</a:t>
            </a:r>
            <a:r>
              <a:rPr lang="en-US" sz="1100" i="1" kern="1200" dirty="0">
                <a:solidFill>
                  <a:srgbClr val="000000"/>
                </a:solidFill>
                <a:effectLst/>
                <a:latin typeface="Times New Roman" panose="02020603050405020304" pitchFamily="18" charset="0"/>
                <a:ea typeface="Calibri" panose="020F0502020204030204" pitchFamily="34" charset="0"/>
              </a:rPr>
              <a:t> </a:t>
            </a:r>
            <a:r>
              <a:rPr lang="en-US" sz="1100" kern="1200" dirty="0">
                <a:solidFill>
                  <a:srgbClr val="000000"/>
                </a:solidFill>
                <a:effectLst/>
                <a:latin typeface="Times New Roman" panose="02020603050405020304" pitchFamily="18" charset="0"/>
                <a:ea typeface="Calibri" panose="020F0502020204030204" pitchFamily="34" charset="0"/>
              </a:rPr>
              <a:t>LL</a:t>
            </a:r>
            <a:r>
              <a:rPr lang="en-US" sz="1100" i="1" kern="1200" dirty="0">
                <a:solidFill>
                  <a:srgbClr val="000000"/>
                </a:solidFill>
                <a:effectLst/>
                <a:latin typeface="Times New Roman" panose="02020603050405020304" pitchFamily="18" charset="0"/>
                <a:ea typeface="Calibri" panose="020F0502020204030204" pitchFamily="34" charset="0"/>
              </a:rPr>
              <a:t> </a:t>
            </a:r>
            <a:r>
              <a:rPr lang="en-US" sz="1100" kern="1200" dirty="0">
                <a:solidFill>
                  <a:srgbClr val="000000"/>
                </a:solidFill>
                <a:effectLst/>
                <a:latin typeface="Times New Roman" panose="02020603050405020304" pitchFamily="18" charset="0"/>
                <a:ea typeface="Calibri" panose="020F0502020204030204" pitchFamily="34" charset="0"/>
              </a:rPr>
              <a:t>and HL cells by incubation for 30 min at the light intensity of 100 </a:t>
            </a:r>
            <a:r>
              <a:rPr lang="el-GR" sz="1100" kern="1200" dirty="0">
                <a:solidFill>
                  <a:srgbClr val="000000"/>
                </a:solidFill>
                <a:effectLst/>
                <a:latin typeface="Times New Roman" panose="02020603050405020304" pitchFamily="18" charset="0"/>
                <a:ea typeface="Calibri" panose="020F0502020204030204" pitchFamily="34" charset="0"/>
              </a:rPr>
              <a:t>μ</a:t>
            </a:r>
            <a:r>
              <a:rPr lang="en-US" sz="1100" kern="1200" dirty="0">
                <a:solidFill>
                  <a:srgbClr val="000000"/>
                </a:solidFill>
                <a:effectLst/>
                <a:latin typeface="Times New Roman" panose="02020603050405020304" pitchFamily="18" charset="0"/>
                <a:ea typeface="Calibri" panose="020F0502020204030204" pitchFamily="34" charset="0"/>
              </a:rPr>
              <a:t>mol photons m</a:t>
            </a:r>
            <a:r>
              <a:rPr lang="en-US" sz="1100" kern="1200" baseline="30000" dirty="0">
                <a:solidFill>
                  <a:srgbClr val="000000"/>
                </a:solidFill>
                <a:effectLst/>
                <a:latin typeface="Times New Roman" panose="02020603050405020304" pitchFamily="18" charset="0"/>
                <a:ea typeface="Calibri" panose="020F0502020204030204" pitchFamily="34" charset="0"/>
              </a:rPr>
              <a:t>-2</a:t>
            </a:r>
            <a:r>
              <a:rPr lang="en-US" sz="1100" kern="1200" dirty="0">
                <a:solidFill>
                  <a:srgbClr val="000000"/>
                </a:solidFill>
                <a:effectLst/>
                <a:latin typeface="Times New Roman" panose="02020603050405020304" pitchFamily="18" charset="0"/>
                <a:ea typeface="Calibri" panose="020F0502020204030204" pitchFamily="34" charset="0"/>
              </a:rPr>
              <a:t> sec</a:t>
            </a:r>
            <a:r>
              <a:rPr lang="en-US" sz="1100" kern="1200" baseline="30000" dirty="0">
                <a:solidFill>
                  <a:srgbClr val="000000"/>
                </a:solidFill>
                <a:effectLst/>
                <a:latin typeface="Times New Roman" panose="02020603050405020304" pitchFamily="18" charset="0"/>
                <a:ea typeface="Calibri" panose="020F0502020204030204" pitchFamily="34" charset="0"/>
              </a:rPr>
              <a:t>-1</a:t>
            </a:r>
            <a:r>
              <a:rPr lang="en-US" sz="1100" kern="1200" dirty="0">
                <a:solidFill>
                  <a:srgbClr val="000000"/>
                </a:solidFill>
                <a:effectLst/>
                <a:latin typeface="Times New Roman" panose="02020603050405020304" pitchFamily="18" charset="0"/>
                <a:ea typeface="Calibri" panose="020F0502020204030204" pitchFamily="34" charset="0"/>
              </a:rPr>
              <a:t>, with gentle shaking.</a:t>
            </a:r>
            <a:r>
              <a:rPr lang="en-US" sz="1200" dirty="0">
                <a:effectLst/>
                <a:latin typeface="Times New Roman" panose="02020603050405020304" pitchFamily="18" charset="0"/>
                <a:ea typeface="Times New Roman" panose="02020603050405020304" pitchFamily="18" charset="0"/>
              </a:rPr>
              <a:t> </a:t>
            </a:r>
            <a:r>
              <a:rPr lang="en-US" sz="1100" b="1" kern="1200" dirty="0">
                <a:solidFill>
                  <a:srgbClr val="000000"/>
                </a:solidFill>
                <a:effectLst/>
                <a:latin typeface="Times New Roman" panose="02020603050405020304" pitchFamily="18" charset="0"/>
                <a:ea typeface="Calibri" panose="020F0502020204030204" pitchFamily="34" charset="0"/>
              </a:rPr>
              <a:t>B) </a:t>
            </a:r>
            <a:r>
              <a:rPr lang="en-US" sz="1100" kern="1200" dirty="0">
                <a:solidFill>
                  <a:srgbClr val="000000"/>
                </a:solidFill>
                <a:effectLst/>
                <a:latin typeface="Times New Roman" panose="02020603050405020304" pitchFamily="18" charset="0"/>
                <a:ea typeface="Calibri" panose="020F0502020204030204" pitchFamily="34" charset="0"/>
              </a:rPr>
              <a:t>The cells were pelleted and resuspended in a fresh TAP medium and loaded onto a microscope slide and applied to a spinning disk confocal microscope with a Z stacking of 8 </a:t>
            </a:r>
            <a:r>
              <a:rPr lang="en-US" sz="1100" kern="1200" dirty="0">
                <a:solidFill>
                  <a:srgbClr val="000000"/>
                </a:solidFill>
                <a:effectLst/>
                <a:latin typeface="Symbol" panose="05050102010706020507" pitchFamily="18" charset="2"/>
                <a:ea typeface="Symbol" panose="05050102010706020507" pitchFamily="18" charset="2"/>
                <a:cs typeface="Symbol" panose="05050102010706020507" pitchFamily="18" charset="2"/>
              </a:rPr>
              <a:t>m</a:t>
            </a:r>
            <a:r>
              <a:rPr lang="en-US" sz="1100" kern="1200" dirty="0">
                <a:solidFill>
                  <a:srgbClr val="000000"/>
                </a:solidFill>
                <a:effectLst/>
                <a:latin typeface="Times New Roman" panose="02020603050405020304" pitchFamily="18" charset="0"/>
                <a:ea typeface="Calibri" panose="020F0502020204030204" pitchFamily="34" charset="0"/>
              </a:rPr>
              <a:t>m around the cell central plain.</a:t>
            </a:r>
            <a:r>
              <a:rPr lang="en-US" sz="1200" dirty="0">
                <a:effectLst/>
                <a:latin typeface="Times New Roman" panose="02020603050405020304" pitchFamily="18" charset="0"/>
                <a:ea typeface="Times New Roman" panose="02020603050405020304" pitchFamily="18" charset="0"/>
              </a:rPr>
              <a:t> </a:t>
            </a:r>
            <a:r>
              <a:rPr lang="en-US" sz="1100" b="1" kern="1200" dirty="0">
                <a:solidFill>
                  <a:srgbClr val="000000"/>
                </a:solidFill>
                <a:effectLst/>
                <a:latin typeface="Times New Roman" panose="02020603050405020304" pitchFamily="18" charset="0"/>
                <a:ea typeface="Calibri" panose="020F0502020204030204" pitchFamily="34" charset="0"/>
              </a:rPr>
              <a:t>C) </a:t>
            </a:r>
            <a:r>
              <a:rPr lang="en-US" sz="1100" kern="1200" dirty="0">
                <a:solidFill>
                  <a:srgbClr val="000000"/>
                </a:solidFill>
                <a:effectLst/>
                <a:latin typeface="Times New Roman" panose="02020603050405020304" pitchFamily="18" charset="0"/>
                <a:ea typeface="Calibri" panose="020F0502020204030204" pitchFamily="34" charset="0"/>
              </a:rPr>
              <a:t>Induction of high light stress was initiated within the microscope using red LED illumination. This wavelength selection (~600 nm) was chosen to specifically activate photosynthesis. </a:t>
            </a:r>
            <a:r>
              <a:rPr lang="en-US" sz="1100" b="1" kern="1200" dirty="0">
                <a:solidFill>
                  <a:srgbClr val="000000"/>
                </a:solidFill>
                <a:effectLst/>
                <a:latin typeface="Times New Roman" panose="02020603050405020304" pitchFamily="18" charset="0"/>
                <a:ea typeface="Calibri" panose="020F0502020204030204" pitchFamily="34" charset="0"/>
              </a:rPr>
              <a:t>D) </a:t>
            </a:r>
            <a:r>
              <a:rPr lang="en-US" sz="11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OSG fluorescence</a:t>
            </a:r>
            <a:r>
              <a:rPr lang="en-US" sz="1100" kern="1200" dirty="0">
                <a:solidFill>
                  <a:srgbClr val="000000"/>
                </a:solidFill>
                <a:effectLst/>
                <a:latin typeface="Times New Roman" panose="02020603050405020304" pitchFamily="18" charset="0"/>
                <a:ea typeface="Calibri" panose="020F0502020204030204" pitchFamily="34" charset="0"/>
              </a:rPr>
              <a:t> (excitation at 488 nm/emission at 530 nm)</a:t>
            </a:r>
            <a:r>
              <a:rPr lang="en-US" sz="11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was recorded. </a:t>
            </a:r>
            <a:r>
              <a:rPr lang="en-US" sz="1100" kern="1200" dirty="0">
                <a:solidFill>
                  <a:srgbClr val="000000"/>
                </a:solidFill>
                <a:effectLst/>
                <a:latin typeface="Times New Roman" panose="02020603050405020304" pitchFamily="18" charset="0"/>
                <a:ea typeface="Calibri" panose="020F0502020204030204" pitchFamily="34" charset="0"/>
              </a:rPr>
              <a:t>To locate the chloroplast, chlorophyll fluorescence (excitation at 430 nm/emission at 680 nm) was concurrently recorded. </a:t>
            </a:r>
            <a:r>
              <a:rPr lang="en-US" sz="1100" b="1"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E) </a:t>
            </a:r>
            <a:r>
              <a:rPr lang="en-US" sz="11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Chlorophyll fluorescence was detected in different focused plains before and after the red high light treatment and a 3D model of the fluorescence was created by Z-stacking in the IMARIS program. Due to the limited permeability of SOSG, green fluorescence appeared on the cell membrane throughout the experiments. To subtract the access fluorescence that was not contributed by the photosynthetic-driven </a:t>
            </a:r>
            <a:r>
              <a:rPr lang="en-US" sz="1100" kern="100" baseline="30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1</a:t>
            </a:r>
            <a:r>
              <a:rPr lang="en-US" sz="11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O</a:t>
            </a:r>
            <a:r>
              <a:rPr lang="en-US" sz="1100" kern="100" baseline="-250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2</a:t>
            </a:r>
            <a:r>
              <a:rPr lang="en-US" sz="11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 formation, a chloroplast volume was constructed from the chlorophyll fluorescence. </a:t>
            </a:r>
            <a:r>
              <a:rPr lang="en-US" sz="1100" b="1"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F) </a:t>
            </a:r>
            <a:r>
              <a:rPr lang="en-US" sz="1100" kern="100" dirty="0">
                <a:solidFill>
                  <a:srgbClr val="000000"/>
                </a:solidFill>
                <a:effectLst/>
                <a:latin typeface="Times New Roman" panose="02020603050405020304" pitchFamily="18" charset="0"/>
                <a:ea typeface="Calibri" panose="020F0502020204030204" pitchFamily="34" charset="0"/>
                <a:cs typeface="Arial" panose="020B0604020202020204" pitchFamily="34" charset="0"/>
              </a:rPr>
              <a:t>SOSG fluorescence was only calculated from the chloroplast volume. </a:t>
            </a:r>
            <a:r>
              <a:rPr lang="en-US" sz="1100" kern="1200" dirty="0">
                <a:solidFill>
                  <a:srgbClr val="000000"/>
                </a:solidFill>
                <a:effectLst/>
                <a:latin typeface="Times New Roman" panose="02020603050405020304" pitchFamily="18" charset="0"/>
                <a:ea typeface="Calibri" panose="020F0502020204030204" pitchFamily="34" charset="0"/>
              </a:rPr>
              <a:t>This approach ensures the isolation of photosynthetic singlet oxygen formation, offering a comprehensive insight into the dynamics of singlet oxygen accumulation within the cellular context.</a:t>
            </a:r>
            <a:endParaRPr lang="en-IL" sz="1200" dirty="0">
              <a:effectLst/>
              <a:latin typeface="Times New Roman" panose="02020603050405020304" pitchFamily="18" charset="0"/>
              <a:ea typeface="Times New Roman" panose="02020603050405020304" pitchFamily="18" charset="0"/>
            </a:endParaRPr>
          </a:p>
          <a:p>
            <a:pPr algn="just">
              <a:lnSpc>
                <a:spcPct val="150000"/>
              </a:lnSpc>
              <a:spcAft>
                <a:spcPts val="0"/>
              </a:spcAft>
            </a:pPr>
            <a:r>
              <a:rPr lang="en-GB" sz="1100" b="1" kern="1200" dirty="0">
                <a:solidFill>
                  <a:srgbClr val="000000"/>
                </a:solidFill>
                <a:effectLst/>
                <a:latin typeface="Times New Roman" panose="02020603050405020304" pitchFamily="18" charset="0"/>
                <a:ea typeface="Times New Roman" panose="02020603050405020304" pitchFamily="18" charset="0"/>
              </a:rPr>
              <a:t> </a:t>
            </a:r>
            <a:endParaRPr lang="en-IL" sz="1200" dirty="0">
              <a:effectLst/>
              <a:latin typeface="Times New Roman" panose="02020603050405020304" pitchFamily="18" charset="0"/>
              <a:ea typeface="Times New Roman" panose="02020603050405020304" pitchFamily="18" charset="0"/>
            </a:endParaRPr>
          </a:p>
        </p:txBody>
      </p:sp>
    </p:spTree>
    <p:extLst>
      <p:ext uri="{BB962C8B-B14F-4D97-AF65-F5344CB8AC3E}">
        <p14:creationId xmlns:p14="http://schemas.microsoft.com/office/powerpoint/2010/main" val="3642643054"/>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63</TotalTime>
  <Words>332</Words>
  <Application>Microsoft Office PowerPoint</Application>
  <PresentationFormat>A4 Paper (210x297 mm)</PresentationFormat>
  <Paragraphs>17</Paragraphs>
  <Slides>2</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vt:i4>
      </vt:variant>
    </vt:vector>
  </HeadingPairs>
  <TitlesOfParts>
    <vt:vector size="8" baseType="lpstr">
      <vt:lpstr>Arial</vt:lpstr>
      <vt:lpstr>Calibri</vt:lpstr>
      <vt:lpstr>Calibri Light</vt:lpstr>
      <vt:lpstr>Symbol</vt:lpstr>
      <vt:lpstr>Times New Roman</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Gadi Schuster Lab</dc:creator>
  <cp:lastModifiedBy>Gadi Schuster Lab</cp:lastModifiedBy>
  <cp:revision>12</cp:revision>
  <dcterms:created xsi:type="dcterms:W3CDTF">2024-05-03T07:50:48Z</dcterms:created>
  <dcterms:modified xsi:type="dcterms:W3CDTF">2024-09-19T19:53:42Z</dcterms:modified>
</cp:coreProperties>
</file>